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61" r:id="rId2"/>
  </p:sldIdLst>
  <p:sldSz cx="9144000" cy="6858000" type="screen4x3"/>
  <p:notesSz cx="7315200" cy="96012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4380"/>
    <p:restoredTop sz="97527" autoAdjust="0"/>
  </p:normalViewPr>
  <p:slideViewPr>
    <p:cSldViewPr>
      <p:cViewPr>
        <p:scale>
          <a:sx n="98" d="100"/>
          <a:sy n="98" d="100"/>
        </p:scale>
        <p:origin x="-2202" y="-3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 140"/>
          <p:cNvGrpSpPr/>
          <p:nvPr/>
        </p:nvGrpSpPr>
        <p:grpSpPr>
          <a:xfrm>
            <a:off x="2555776" y="1292794"/>
            <a:ext cx="3888433" cy="3340310"/>
            <a:chOff x="2555776" y="1292794"/>
            <a:chExt cx="3888433" cy="3340310"/>
          </a:xfrm>
        </p:grpSpPr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2643424" y="1292794"/>
              <a:ext cx="3030024" cy="1693532"/>
              <a:chOff x="4163321" y="1449587"/>
              <a:chExt cx="2250759" cy="1257987"/>
            </a:xfrm>
          </p:grpSpPr>
          <p:sp>
            <p:nvSpPr>
              <p:cNvPr id="3" name="Rectangle 85"/>
              <p:cNvSpPr>
                <a:spLocks noChangeArrowheads="1"/>
              </p:cNvSpPr>
              <p:nvPr/>
            </p:nvSpPr>
            <p:spPr bwMode="auto">
              <a:xfrm rot="16200000">
                <a:off x="4082351" y="1936336"/>
                <a:ext cx="276252" cy="1143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1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he-IL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unt</a:t>
                </a:r>
                <a:endParaRPr kumimoji="0" lang="he-IL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5229932" y="2524676"/>
                <a:ext cx="579928" cy="182898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1000" b="1" dirty="0" smtClean="0">
                    <a:latin typeface="+mj-lt"/>
                  </a:rPr>
                  <a:t>CD3</a:t>
                </a:r>
                <a:endParaRPr lang="he-IL" sz="1000" b="1" dirty="0">
                  <a:latin typeface="+mj-lt"/>
                </a:endParaRPr>
              </a:p>
            </p:txBody>
          </p:sp>
          <p:grpSp>
            <p:nvGrpSpPr>
              <p:cNvPr id="9" name="Group 330"/>
              <p:cNvGrpSpPr/>
              <p:nvPr/>
            </p:nvGrpSpPr>
            <p:grpSpPr>
              <a:xfrm>
                <a:off x="4507370" y="1596354"/>
                <a:ext cx="859699" cy="859701"/>
                <a:chOff x="2188532" y="1416425"/>
                <a:chExt cx="859699" cy="859701"/>
              </a:xfrm>
            </p:grpSpPr>
            <p:sp>
              <p:nvSpPr>
                <p:cNvPr id="81" name="Freeform 6"/>
                <p:cNvSpPr>
                  <a:spLocks/>
                </p:cNvSpPr>
                <p:nvPr/>
              </p:nvSpPr>
              <p:spPr bwMode="auto">
                <a:xfrm>
                  <a:off x="2211498" y="1445521"/>
                  <a:ext cx="836733" cy="804553"/>
                </a:xfrm>
                <a:custGeom>
                  <a:avLst/>
                  <a:gdLst/>
                  <a:ahLst/>
                  <a:cxnLst>
                    <a:cxn ang="0">
                      <a:pos x="19" y="2358"/>
                    </a:cxn>
                    <a:cxn ang="0">
                      <a:pos x="67" y="2349"/>
                    </a:cxn>
                    <a:cxn ang="0">
                      <a:pos x="114" y="2349"/>
                    </a:cxn>
                    <a:cxn ang="0">
                      <a:pos x="162" y="2339"/>
                    </a:cxn>
                    <a:cxn ang="0">
                      <a:pos x="210" y="2339"/>
                    </a:cxn>
                    <a:cxn ang="0">
                      <a:pos x="257" y="2300"/>
                    </a:cxn>
                    <a:cxn ang="0">
                      <a:pos x="305" y="2291"/>
                    </a:cxn>
                    <a:cxn ang="0">
                      <a:pos x="353" y="2262"/>
                    </a:cxn>
                    <a:cxn ang="0">
                      <a:pos x="400" y="2204"/>
                    </a:cxn>
                    <a:cxn ang="0">
                      <a:pos x="448" y="2175"/>
                    </a:cxn>
                    <a:cxn ang="0">
                      <a:pos x="496" y="2078"/>
                    </a:cxn>
                    <a:cxn ang="0">
                      <a:pos x="543" y="1982"/>
                    </a:cxn>
                    <a:cxn ang="0">
                      <a:pos x="591" y="1808"/>
                    </a:cxn>
                    <a:cxn ang="0">
                      <a:pos x="639" y="1537"/>
                    </a:cxn>
                    <a:cxn ang="0">
                      <a:pos x="686" y="1295"/>
                    </a:cxn>
                    <a:cxn ang="0">
                      <a:pos x="734" y="803"/>
                    </a:cxn>
                    <a:cxn ang="0">
                      <a:pos x="782" y="484"/>
                    </a:cxn>
                    <a:cxn ang="0">
                      <a:pos x="829" y="78"/>
                    </a:cxn>
                    <a:cxn ang="0">
                      <a:pos x="877" y="58"/>
                    </a:cxn>
                    <a:cxn ang="0">
                      <a:pos x="925" y="406"/>
                    </a:cxn>
                    <a:cxn ang="0">
                      <a:pos x="972" y="1025"/>
                    </a:cxn>
                    <a:cxn ang="0">
                      <a:pos x="1020" y="1537"/>
                    </a:cxn>
                    <a:cxn ang="0">
                      <a:pos x="1068" y="1953"/>
                    </a:cxn>
                    <a:cxn ang="0">
                      <a:pos x="1115" y="2155"/>
                    </a:cxn>
                    <a:cxn ang="0">
                      <a:pos x="1163" y="2242"/>
                    </a:cxn>
                    <a:cxn ang="0">
                      <a:pos x="1211" y="2281"/>
                    </a:cxn>
                    <a:cxn ang="0">
                      <a:pos x="1258" y="2300"/>
                    </a:cxn>
                    <a:cxn ang="0">
                      <a:pos x="1306" y="2300"/>
                    </a:cxn>
                    <a:cxn ang="0">
                      <a:pos x="1354" y="2291"/>
                    </a:cxn>
                    <a:cxn ang="0">
                      <a:pos x="1401" y="2271"/>
                    </a:cxn>
                    <a:cxn ang="0">
                      <a:pos x="1449" y="2242"/>
                    </a:cxn>
                    <a:cxn ang="0">
                      <a:pos x="1497" y="2223"/>
                    </a:cxn>
                    <a:cxn ang="0">
                      <a:pos x="1544" y="2155"/>
                    </a:cxn>
                    <a:cxn ang="0">
                      <a:pos x="1592" y="2098"/>
                    </a:cxn>
                    <a:cxn ang="0">
                      <a:pos x="1640" y="2020"/>
                    </a:cxn>
                    <a:cxn ang="0">
                      <a:pos x="1687" y="2020"/>
                    </a:cxn>
                    <a:cxn ang="0">
                      <a:pos x="1735" y="2059"/>
                    </a:cxn>
                    <a:cxn ang="0">
                      <a:pos x="1783" y="2020"/>
                    </a:cxn>
                    <a:cxn ang="0">
                      <a:pos x="1830" y="1924"/>
                    </a:cxn>
                    <a:cxn ang="0">
                      <a:pos x="1878" y="2040"/>
                    </a:cxn>
                    <a:cxn ang="0">
                      <a:pos x="1926" y="2242"/>
                    </a:cxn>
                    <a:cxn ang="0">
                      <a:pos x="1973" y="2349"/>
                    </a:cxn>
                    <a:cxn ang="0">
                      <a:pos x="2021" y="2378"/>
                    </a:cxn>
                    <a:cxn ang="0">
                      <a:pos x="2069" y="2378"/>
                    </a:cxn>
                    <a:cxn ang="0">
                      <a:pos x="2116" y="2378"/>
                    </a:cxn>
                    <a:cxn ang="0">
                      <a:pos x="2164" y="2378"/>
                    </a:cxn>
                    <a:cxn ang="0">
                      <a:pos x="2212" y="2378"/>
                    </a:cxn>
                    <a:cxn ang="0">
                      <a:pos x="2259" y="2378"/>
                    </a:cxn>
                    <a:cxn ang="0">
                      <a:pos x="2307" y="2378"/>
                    </a:cxn>
                    <a:cxn ang="0">
                      <a:pos x="2355" y="2378"/>
                    </a:cxn>
                    <a:cxn ang="0">
                      <a:pos x="2402" y="2378"/>
                    </a:cxn>
                    <a:cxn ang="0">
                      <a:pos x="2441" y="2378"/>
                    </a:cxn>
                  </a:cxnLst>
                  <a:rect l="0" t="0" r="r" b="b"/>
                  <a:pathLst>
                    <a:path w="2441" h="2378">
                      <a:moveTo>
                        <a:pt x="0" y="2378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9" y="1885"/>
                      </a:lnTo>
                      <a:lnTo>
                        <a:pt x="19" y="2358"/>
                      </a:lnTo>
                      <a:lnTo>
                        <a:pt x="28" y="2358"/>
                      </a:lnTo>
                      <a:lnTo>
                        <a:pt x="38" y="2358"/>
                      </a:lnTo>
                      <a:lnTo>
                        <a:pt x="47" y="2349"/>
                      </a:lnTo>
                      <a:lnTo>
                        <a:pt x="57" y="2349"/>
                      </a:lnTo>
                      <a:lnTo>
                        <a:pt x="67" y="2349"/>
                      </a:lnTo>
                      <a:lnTo>
                        <a:pt x="76" y="2349"/>
                      </a:lnTo>
                      <a:lnTo>
                        <a:pt x="86" y="2349"/>
                      </a:lnTo>
                      <a:lnTo>
                        <a:pt x="95" y="2349"/>
                      </a:lnTo>
                      <a:lnTo>
                        <a:pt x="105" y="2349"/>
                      </a:lnTo>
                      <a:lnTo>
                        <a:pt x="114" y="2349"/>
                      </a:lnTo>
                      <a:lnTo>
                        <a:pt x="124" y="2349"/>
                      </a:lnTo>
                      <a:lnTo>
                        <a:pt x="133" y="2349"/>
                      </a:lnTo>
                      <a:lnTo>
                        <a:pt x="143" y="2349"/>
                      </a:lnTo>
                      <a:lnTo>
                        <a:pt x="152" y="2339"/>
                      </a:lnTo>
                      <a:lnTo>
                        <a:pt x="162" y="2339"/>
                      </a:lnTo>
                      <a:lnTo>
                        <a:pt x="171" y="2329"/>
                      </a:lnTo>
                      <a:lnTo>
                        <a:pt x="181" y="2320"/>
                      </a:lnTo>
                      <a:lnTo>
                        <a:pt x="190" y="2320"/>
                      </a:lnTo>
                      <a:lnTo>
                        <a:pt x="200" y="2329"/>
                      </a:lnTo>
                      <a:lnTo>
                        <a:pt x="210" y="2339"/>
                      </a:lnTo>
                      <a:lnTo>
                        <a:pt x="219" y="2329"/>
                      </a:lnTo>
                      <a:lnTo>
                        <a:pt x="229" y="2320"/>
                      </a:lnTo>
                      <a:lnTo>
                        <a:pt x="238" y="2320"/>
                      </a:lnTo>
                      <a:lnTo>
                        <a:pt x="248" y="2310"/>
                      </a:lnTo>
                      <a:lnTo>
                        <a:pt x="257" y="2300"/>
                      </a:lnTo>
                      <a:lnTo>
                        <a:pt x="267" y="2291"/>
                      </a:lnTo>
                      <a:lnTo>
                        <a:pt x="276" y="2291"/>
                      </a:lnTo>
                      <a:lnTo>
                        <a:pt x="286" y="2310"/>
                      </a:lnTo>
                      <a:lnTo>
                        <a:pt x="295" y="2310"/>
                      </a:lnTo>
                      <a:lnTo>
                        <a:pt x="305" y="2291"/>
                      </a:lnTo>
                      <a:lnTo>
                        <a:pt x="314" y="2271"/>
                      </a:lnTo>
                      <a:lnTo>
                        <a:pt x="324" y="2262"/>
                      </a:lnTo>
                      <a:lnTo>
                        <a:pt x="333" y="2262"/>
                      </a:lnTo>
                      <a:lnTo>
                        <a:pt x="343" y="2262"/>
                      </a:lnTo>
                      <a:lnTo>
                        <a:pt x="353" y="2262"/>
                      </a:lnTo>
                      <a:lnTo>
                        <a:pt x="362" y="2262"/>
                      </a:lnTo>
                      <a:lnTo>
                        <a:pt x="372" y="2242"/>
                      </a:lnTo>
                      <a:lnTo>
                        <a:pt x="381" y="2223"/>
                      </a:lnTo>
                      <a:lnTo>
                        <a:pt x="391" y="2213"/>
                      </a:lnTo>
                      <a:lnTo>
                        <a:pt x="400" y="2204"/>
                      </a:lnTo>
                      <a:lnTo>
                        <a:pt x="410" y="2204"/>
                      </a:lnTo>
                      <a:lnTo>
                        <a:pt x="419" y="2194"/>
                      </a:lnTo>
                      <a:lnTo>
                        <a:pt x="429" y="2194"/>
                      </a:lnTo>
                      <a:lnTo>
                        <a:pt x="438" y="2194"/>
                      </a:lnTo>
                      <a:lnTo>
                        <a:pt x="448" y="2175"/>
                      </a:lnTo>
                      <a:lnTo>
                        <a:pt x="457" y="2146"/>
                      </a:lnTo>
                      <a:lnTo>
                        <a:pt x="467" y="2136"/>
                      </a:lnTo>
                      <a:lnTo>
                        <a:pt x="476" y="2117"/>
                      </a:lnTo>
                      <a:lnTo>
                        <a:pt x="486" y="2117"/>
                      </a:lnTo>
                      <a:lnTo>
                        <a:pt x="496" y="2078"/>
                      </a:lnTo>
                      <a:lnTo>
                        <a:pt x="505" y="2040"/>
                      </a:lnTo>
                      <a:lnTo>
                        <a:pt x="515" y="2030"/>
                      </a:lnTo>
                      <a:lnTo>
                        <a:pt x="524" y="1991"/>
                      </a:lnTo>
                      <a:lnTo>
                        <a:pt x="534" y="1953"/>
                      </a:lnTo>
                      <a:lnTo>
                        <a:pt x="543" y="1982"/>
                      </a:lnTo>
                      <a:lnTo>
                        <a:pt x="553" y="1962"/>
                      </a:lnTo>
                      <a:lnTo>
                        <a:pt x="562" y="1885"/>
                      </a:lnTo>
                      <a:lnTo>
                        <a:pt x="572" y="1837"/>
                      </a:lnTo>
                      <a:lnTo>
                        <a:pt x="581" y="1817"/>
                      </a:lnTo>
                      <a:lnTo>
                        <a:pt x="591" y="1808"/>
                      </a:lnTo>
                      <a:lnTo>
                        <a:pt x="600" y="1808"/>
                      </a:lnTo>
                      <a:lnTo>
                        <a:pt x="610" y="1750"/>
                      </a:lnTo>
                      <a:lnTo>
                        <a:pt x="620" y="1653"/>
                      </a:lnTo>
                      <a:lnTo>
                        <a:pt x="629" y="1585"/>
                      </a:lnTo>
                      <a:lnTo>
                        <a:pt x="639" y="1537"/>
                      </a:lnTo>
                      <a:lnTo>
                        <a:pt x="648" y="1518"/>
                      </a:lnTo>
                      <a:lnTo>
                        <a:pt x="658" y="1498"/>
                      </a:lnTo>
                      <a:lnTo>
                        <a:pt x="667" y="1402"/>
                      </a:lnTo>
                      <a:lnTo>
                        <a:pt x="677" y="1421"/>
                      </a:lnTo>
                      <a:lnTo>
                        <a:pt x="686" y="1295"/>
                      </a:lnTo>
                      <a:lnTo>
                        <a:pt x="696" y="1218"/>
                      </a:lnTo>
                      <a:lnTo>
                        <a:pt x="705" y="1131"/>
                      </a:lnTo>
                      <a:lnTo>
                        <a:pt x="715" y="1160"/>
                      </a:lnTo>
                      <a:lnTo>
                        <a:pt x="724" y="996"/>
                      </a:lnTo>
                      <a:lnTo>
                        <a:pt x="734" y="803"/>
                      </a:lnTo>
                      <a:lnTo>
                        <a:pt x="743" y="861"/>
                      </a:lnTo>
                      <a:lnTo>
                        <a:pt x="753" y="706"/>
                      </a:lnTo>
                      <a:lnTo>
                        <a:pt x="763" y="658"/>
                      </a:lnTo>
                      <a:lnTo>
                        <a:pt x="772" y="648"/>
                      </a:lnTo>
                      <a:lnTo>
                        <a:pt x="782" y="484"/>
                      </a:lnTo>
                      <a:lnTo>
                        <a:pt x="791" y="609"/>
                      </a:lnTo>
                      <a:lnTo>
                        <a:pt x="801" y="455"/>
                      </a:lnTo>
                      <a:lnTo>
                        <a:pt x="810" y="319"/>
                      </a:lnTo>
                      <a:lnTo>
                        <a:pt x="820" y="184"/>
                      </a:lnTo>
                      <a:lnTo>
                        <a:pt x="829" y="78"/>
                      </a:lnTo>
                      <a:lnTo>
                        <a:pt x="839" y="116"/>
                      </a:lnTo>
                      <a:lnTo>
                        <a:pt x="848" y="165"/>
                      </a:lnTo>
                      <a:lnTo>
                        <a:pt x="858" y="97"/>
                      </a:lnTo>
                      <a:lnTo>
                        <a:pt x="867" y="165"/>
                      </a:lnTo>
                      <a:lnTo>
                        <a:pt x="877" y="58"/>
                      </a:lnTo>
                      <a:lnTo>
                        <a:pt x="886" y="126"/>
                      </a:lnTo>
                      <a:lnTo>
                        <a:pt x="896" y="174"/>
                      </a:lnTo>
                      <a:lnTo>
                        <a:pt x="906" y="271"/>
                      </a:lnTo>
                      <a:lnTo>
                        <a:pt x="915" y="271"/>
                      </a:lnTo>
                      <a:lnTo>
                        <a:pt x="925" y="406"/>
                      </a:lnTo>
                      <a:lnTo>
                        <a:pt x="934" y="513"/>
                      </a:lnTo>
                      <a:lnTo>
                        <a:pt x="944" y="580"/>
                      </a:lnTo>
                      <a:lnTo>
                        <a:pt x="953" y="716"/>
                      </a:lnTo>
                      <a:lnTo>
                        <a:pt x="963" y="861"/>
                      </a:lnTo>
                      <a:lnTo>
                        <a:pt x="972" y="1025"/>
                      </a:lnTo>
                      <a:lnTo>
                        <a:pt x="982" y="1054"/>
                      </a:lnTo>
                      <a:lnTo>
                        <a:pt x="991" y="1189"/>
                      </a:lnTo>
                      <a:lnTo>
                        <a:pt x="1001" y="1344"/>
                      </a:lnTo>
                      <a:lnTo>
                        <a:pt x="1010" y="1431"/>
                      </a:lnTo>
                      <a:lnTo>
                        <a:pt x="1020" y="1537"/>
                      </a:lnTo>
                      <a:lnTo>
                        <a:pt x="1029" y="1634"/>
                      </a:lnTo>
                      <a:lnTo>
                        <a:pt x="1039" y="1730"/>
                      </a:lnTo>
                      <a:lnTo>
                        <a:pt x="1049" y="1808"/>
                      </a:lnTo>
                      <a:lnTo>
                        <a:pt x="1058" y="1885"/>
                      </a:lnTo>
                      <a:lnTo>
                        <a:pt x="1068" y="1953"/>
                      </a:lnTo>
                      <a:lnTo>
                        <a:pt x="1077" y="2011"/>
                      </a:lnTo>
                      <a:lnTo>
                        <a:pt x="1087" y="2059"/>
                      </a:lnTo>
                      <a:lnTo>
                        <a:pt x="1096" y="2098"/>
                      </a:lnTo>
                      <a:lnTo>
                        <a:pt x="1106" y="2126"/>
                      </a:lnTo>
                      <a:lnTo>
                        <a:pt x="1115" y="2155"/>
                      </a:lnTo>
                      <a:lnTo>
                        <a:pt x="1125" y="2184"/>
                      </a:lnTo>
                      <a:lnTo>
                        <a:pt x="1134" y="2204"/>
                      </a:lnTo>
                      <a:lnTo>
                        <a:pt x="1144" y="2223"/>
                      </a:lnTo>
                      <a:lnTo>
                        <a:pt x="1153" y="2233"/>
                      </a:lnTo>
                      <a:lnTo>
                        <a:pt x="1163" y="2242"/>
                      </a:lnTo>
                      <a:lnTo>
                        <a:pt x="1173" y="2252"/>
                      </a:lnTo>
                      <a:lnTo>
                        <a:pt x="1182" y="2262"/>
                      </a:lnTo>
                      <a:lnTo>
                        <a:pt x="1192" y="2271"/>
                      </a:lnTo>
                      <a:lnTo>
                        <a:pt x="1201" y="2281"/>
                      </a:lnTo>
                      <a:lnTo>
                        <a:pt x="1211" y="2281"/>
                      </a:lnTo>
                      <a:lnTo>
                        <a:pt x="1220" y="2291"/>
                      </a:lnTo>
                      <a:lnTo>
                        <a:pt x="1230" y="2291"/>
                      </a:lnTo>
                      <a:lnTo>
                        <a:pt x="1239" y="2300"/>
                      </a:lnTo>
                      <a:lnTo>
                        <a:pt x="1249" y="2300"/>
                      </a:lnTo>
                      <a:lnTo>
                        <a:pt x="1258" y="2300"/>
                      </a:lnTo>
                      <a:lnTo>
                        <a:pt x="1268" y="2300"/>
                      </a:lnTo>
                      <a:lnTo>
                        <a:pt x="1277" y="2300"/>
                      </a:lnTo>
                      <a:lnTo>
                        <a:pt x="1287" y="2300"/>
                      </a:lnTo>
                      <a:lnTo>
                        <a:pt x="1296" y="2300"/>
                      </a:lnTo>
                      <a:lnTo>
                        <a:pt x="1306" y="2300"/>
                      </a:lnTo>
                      <a:lnTo>
                        <a:pt x="1316" y="2300"/>
                      </a:lnTo>
                      <a:lnTo>
                        <a:pt x="1325" y="2300"/>
                      </a:lnTo>
                      <a:lnTo>
                        <a:pt x="1335" y="2300"/>
                      </a:lnTo>
                      <a:lnTo>
                        <a:pt x="1344" y="2291"/>
                      </a:lnTo>
                      <a:lnTo>
                        <a:pt x="1354" y="2291"/>
                      </a:lnTo>
                      <a:lnTo>
                        <a:pt x="1363" y="2281"/>
                      </a:lnTo>
                      <a:lnTo>
                        <a:pt x="1373" y="2281"/>
                      </a:lnTo>
                      <a:lnTo>
                        <a:pt x="1382" y="2281"/>
                      </a:lnTo>
                      <a:lnTo>
                        <a:pt x="1392" y="2271"/>
                      </a:lnTo>
                      <a:lnTo>
                        <a:pt x="1401" y="2271"/>
                      </a:lnTo>
                      <a:lnTo>
                        <a:pt x="1411" y="2262"/>
                      </a:lnTo>
                      <a:lnTo>
                        <a:pt x="1420" y="2252"/>
                      </a:lnTo>
                      <a:lnTo>
                        <a:pt x="1430" y="2252"/>
                      </a:lnTo>
                      <a:lnTo>
                        <a:pt x="1439" y="2242"/>
                      </a:lnTo>
                      <a:lnTo>
                        <a:pt x="1449" y="2242"/>
                      </a:lnTo>
                      <a:lnTo>
                        <a:pt x="1459" y="2242"/>
                      </a:lnTo>
                      <a:lnTo>
                        <a:pt x="1468" y="2242"/>
                      </a:lnTo>
                      <a:lnTo>
                        <a:pt x="1478" y="2233"/>
                      </a:lnTo>
                      <a:lnTo>
                        <a:pt x="1487" y="2223"/>
                      </a:lnTo>
                      <a:lnTo>
                        <a:pt x="1497" y="2223"/>
                      </a:lnTo>
                      <a:lnTo>
                        <a:pt x="1506" y="2213"/>
                      </a:lnTo>
                      <a:lnTo>
                        <a:pt x="1516" y="2204"/>
                      </a:lnTo>
                      <a:lnTo>
                        <a:pt x="1525" y="2184"/>
                      </a:lnTo>
                      <a:lnTo>
                        <a:pt x="1535" y="2175"/>
                      </a:lnTo>
                      <a:lnTo>
                        <a:pt x="1544" y="2155"/>
                      </a:lnTo>
                      <a:lnTo>
                        <a:pt x="1554" y="2146"/>
                      </a:lnTo>
                      <a:lnTo>
                        <a:pt x="1563" y="2136"/>
                      </a:lnTo>
                      <a:lnTo>
                        <a:pt x="1573" y="2126"/>
                      </a:lnTo>
                      <a:lnTo>
                        <a:pt x="1582" y="2107"/>
                      </a:lnTo>
                      <a:lnTo>
                        <a:pt x="1592" y="2098"/>
                      </a:lnTo>
                      <a:lnTo>
                        <a:pt x="1602" y="2069"/>
                      </a:lnTo>
                      <a:lnTo>
                        <a:pt x="1611" y="2059"/>
                      </a:lnTo>
                      <a:lnTo>
                        <a:pt x="1621" y="2049"/>
                      </a:lnTo>
                      <a:lnTo>
                        <a:pt x="1630" y="2030"/>
                      </a:lnTo>
                      <a:lnTo>
                        <a:pt x="1640" y="2020"/>
                      </a:lnTo>
                      <a:lnTo>
                        <a:pt x="1649" y="2011"/>
                      </a:lnTo>
                      <a:lnTo>
                        <a:pt x="1659" y="2011"/>
                      </a:lnTo>
                      <a:lnTo>
                        <a:pt x="1668" y="2011"/>
                      </a:lnTo>
                      <a:lnTo>
                        <a:pt x="1678" y="2020"/>
                      </a:lnTo>
                      <a:lnTo>
                        <a:pt x="1687" y="2020"/>
                      </a:lnTo>
                      <a:lnTo>
                        <a:pt x="1697" y="2020"/>
                      </a:lnTo>
                      <a:lnTo>
                        <a:pt x="1706" y="2040"/>
                      </a:lnTo>
                      <a:lnTo>
                        <a:pt x="1716" y="2049"/>
                      </a:lnTo>
                      <a:lnTo>
                        <a:pt x="1726" y="2059"/>
                      </a:lnTo>
                      <a:lnTo>
                        <a:pt x="1735" y="2059"/>
                      </a:lnTo>
                      <a:lnTo>
                        <a:pt x="1745" y="2059"/>
                      </a:lnTo>
                      <a:lnTo>
                        <a:pt x="1754" y="2049"/>
                      </a:lnTo>
                      <a:lnTo>
                        <a:pt x="1764" y="2040"/>
                      </a:lnTo>
                      <a:lnTo>
                        <a:pt x="1773" y="2030"/>
                      </a:lnTo>
                      <a:lnTo>
                        <a:pt x="1783" y="2020"/>
                      </a:lnTo>
                      <a:lnTo>
                        <a:pt x="1792" y="2001"/>
                      </a:lnTo>
                      <a:lnTo>
                        <a:pt x="1802" y="1972"/>
                      </a:lnTo>
                      <a:lnTo>
                        <a:pt x="1811" y="1962"/>
                      </a:lnTo>
                      <a:lnTo>
                        <a:pt x="1821" y="1943"/>
                      </a:lnTo>
                      <a:lnTo>
                        <a:pt x="1830" y="1924"/>
                      </a:lnTo>
                      <a:lnTo>
                        <a:pt x="1840" y="1943"/>
                      </a:lnTo>
                      <a:lnTo>
                        <a:pt x="1849" y="1953"/>
                      </a:lnTo>
                      <a:lnTo>
                        <a:pt x="1859" y="1962"/>
                      </a:lnTo>
                      <a:lnTo>
                        <a:pt x="1869" y="2001"/>
                      </a:lnTo>
                      <a:lnTo>
                        <a:pt x="1878" y="2040"/>
                      </a:lnTo>
                      <a:lnTo>
                        <a:pt x="1888" y="2078"/>
                      </a:lnTo>
                      <a:lnTo>
                        <a:pt x="1897" y="2126"/>
                      </a:lnTo>
                      <a:lnTo>
                        <a:pt x="1907" y="2175"/>
                      </a:lnTo>
                      <a:lnTo>
                        <a:pt x="1916" y="2213"/>
                      </a:lnTo>
                      <a:lnTo>
                        <a:pt x="1926" y="2242"/>
                      </a:lnTo>
                      <a:lnTo>
                        <a:pt x="1935" y="2281"/>
                      </a:lnTo>
                      <a:lnTo>
                        <a:pt x="1945" y="2310"/>
                      </a:lnTo>
                      <a:lnTo>
                        <a:pt x="1954" y="2329"/>
                      </a:lnTo>
                      <a:lnTo>
                        <a:pt x="1964" y="2339"/>
                      </a:lnTo>
                      <a:lnTo>
                        <a:pt x="1973" y="2349"/>
                      </a:lnTo>
                      <a:lnTo>
                        <a:pt x="1983" y="2358"/>
                      </a:lnTo>
                      <a:lnTo>
                        <a:pt x="1992" y="2368"/>
                      </a:lnTo>
                      <a:lnTo>
                        <a:pt x="2002" y="2368"/>
                      </a:lnTo>
                      <a:lnTo>
                        <a:pt x="2012" y="2378"/>
                      </a:lnTo>
                      <a:lnTo>
                        <a:pt x="2021" y="2378"/>
                      </a:lnTo>
                      <a:lnTo>
                        <a:pt x="2031" y="2378"/>
                      </a:lnTo>
                      <a:lnTo>
                        <a:pt x="2040" y="2378"/>
                      </a:lnTo>
                      <a:lnTo>
                        <a:pt x="2050" y="2378"/>
                      </a:lnTo>
                      <a:lnTo>
                        <a:pt x="2059" y="2378"/>
                      </a:lnTo>
                      <a:lnTo>
                        <a:pt x="2069" y="2378"/>
                      </a:lnTo>
                      <a:lnTo>
                        <a:pt x="2078" y="2378"/>
                      </a:lnTo>
                      <a:lnTo>
                        <a:pt x="2088" y="2378"/>
                      </a:lnTo>
                      <a:lnTo>
                        <a:pt x="2097" y="2378"/>
                      </a:lnTo>
                      <a:lnTo>
                        <a:pt x="2107" y="2378"/>
                      </a:lnTo>
                      <a:lnTo>
                        <a:pt x="2116" y="2378"/>
                      </a:lnTo>
                      <a:lnTo>
                        <a:pt x="2126" y="2378"/>
                      </a:lnTo>
                      <a:lnTo>
                        <a:pt x="2135" y="2378"/>
                      </a:lnTo>
                      <a:lnTo>
                        <a:pt x="2145" y="2378"/>
                      </a:lnTo>
                      <a:lnTo>
                        <a:pt x="2155" y="2378"/>
                      </a:lnTo>
                      <a:lnTo>
                        <a:pt x="2164" y="2378"/>
                      </a:lnTo>
                      <a:lnTo>
                        <a:pt x="2174" y="2378"/>
                      </a:lnTo>
                      <a:lnTo>
                        <a:pt x="2183" y="2378"/>
                      </a:lnTo>
                      <a:lnTo>
                        <a:pt x="2193" y="2378"/>
                      </a:lnTo>
                      <a:lnTo>
                        <a:pt x="2202" y="2378"/>
                      </a:lnTo>
                      <a:lnTo>
                        <a:pt x="2212" y="2378"/>
                      </a:lnTo>
                      <a:lnTo>
                        <a:pt x="2221" y="2378"/>
                      </a:lnTo>
                      <a:lnTo>
                        <a:pt x="2231" y="2378"/>
                      </a:lnTo>
                      <a:lnTo>
                        <a:pt x="2240" y="2378"/>
                      </a:lnTo>
                      <a:lnTo>
                        <a:pt x="2250" y="2378"/>
                      </a:lnTo>
                      <a:lnTo>
                        <a:pt x="2259" y="2378"/>
                      </a:lnTo>
                      <a:lnTo>
                        <a:pt x="2269" y="2378"/>
                      </a:lnTo>
                      <a:lnTo>
                        <a:pt x="2279" y="2378"/>
                      </a:lnTo>
                      <a:lnTo>
                        <a:pt x="2288" y="2378"/>
                      </a:lnTo>
                      <a:lnTo>
                        <a:pt x="2298" y="2378"/>
                      </a:lnTo>
                      <a:lnTo>
                        <a:pt x="2307" y="2378"/>
                      </a:lnTo>
                      <a:lnTo>
                        <a:pt x="2317" y="2378"/>
                      </a:lnTo>
                      <a:lnTo>
                        <a:pt x="2326" y="2378"/>
                      </a:lnTo>
                      <a:lnTo>
                        <a:pt x="2336" y="2378"/>
                      </a:lnTo>
                      <a:lnTo>
                        <a:pt x="2345" y="2378"/>
                      </a:lnTo>
                      <a:lnTo>
                        <a:pt x="2355" y="2378"/>
                      </a:lnTo>
                      <a:lnTo>
                        <a:pt x="2364" y="2378"/>
                      </a:lnTo>
                      <a:lnTo>
                        <a:pt x="2374" y="2378"/>
                      </a:lnTo>
                      <a:lnTo>
                        <a:pt x="2383" y="2378"/>
                      </a:lnTo>
                      <a:lnTo>
                        <a:pt x="2393" y="2378"/>
                      </a:lnTo>
                      <a:lnTo>
                        <a:pt x="2402" y="2378"/>
                      </a:lnTo>
                      <a:lnTo>
                        <a:pt x="2412" y="2378"/>
                      </a:lnTo>
                      <a:lnTo>
                        <a:pt x="2422" y="2368"/>
                      </a:lnTo>
                      <a:lnTo>
                        <a:pt x="2431" y="2358"/>
                      </a:lnTo>
                      <a:lnTo>
                        <a:pt x="2441" y="2358"/>
                      </a:lnTo>
                      <a:lnTo>
                        <a:pt x="2441" y="2378"/>
                      </a:lnTo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82" name="Freeform 7"/>
                <p:cNvSpPr>
                  <a:spLocks/>
                </p:cNvSpPr>
                <p:nvPr/>
              </p:nvSpPr>
              <p:spPr bwMode="auto">
                <a:xfrm>
                  <a:off x="2659172" y="2132335"/>
                  <a:ext cx="258115" cy="33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753" y="0"/>
                    </a:cxn>
                    <a:cxn ang="0">
                      <a:pos x="753" y="0"/>
                    </a:cxn>
                    <a:cxn ang="0">
                      <a:pos x="753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5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53" y="0"/>
                      </a:lnTo>
                      <a:lnTo>
                        <a:pt x="753" y="0"/>
                      </a:lnTo>
                      <a:lnTo>
                        <a:pt x="753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83" name="Freeform 8"/>
                <p:cNvSpPr>
                  <a:spLocks/>
                </p:cNvSpPr>
                <p:nvPr/>
              </p:nvSpPr>
              <p:spPr bwMode="auto">
                <a:xfrm>
                  <a:off x="2659172" y="2116094"/>
                  <a:ext cx="343" cy="3248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0" y="96"/>
                    </a:cxn>
                    <a:cxn ang="0">
                      <a:pos x="0" y="96"/>
                    </a:cxn>
                    <a:cxn ang="0">
                      <a:pos x="0" y="96"/>
                    </a:cxn>
                    <a:cxn ang="0">
                      <a:pos x="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h="9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96"/>
                      </a:lnTo>
                      <a:lnTo>
                        <a:pt x="0" y="96"/>
                      </a:lnTo>
                      <a:lnTo>
                        <a:pt x="0" y="96"/>
                      </a:lnTo>
                      <a:lnTo>
                        <a:pt x="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84" name="Freeform 9"/>
                <p:cNvSpPr>
                  <a:spLocks/>
                </p:cNvSpPr>
                <p:nvPr/>
              </p:nvSpPr>
              <p:spPr bwMode="auto">
                <a:xfrm>
                  <a:off x="2917288" y="2116094"/>
                  <a:ext cx="343" cy="3248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0" y="96"/>
                    </a:cxn>
                    <a:cxn ang="0">
                      <a:pos x="0" y="96"/>
                    </a:cxn>
                    <a:cxn ang="0">
                      <a:pos x="0" y="96"/>
                    </a:cxn>
                    <a:cxn ang="0">
                      <a:pos x="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h="9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96"/>
                      </a:lnTo>
                      <a:lnTo>
                        <a:pt x="0" y="96"/>
                      </a:lnTo>
                      <a:lnTo>
                        <a:pt x="0" y="96"/>
                      </a:lnTo>
                      <a:lnTo>
                        <a:pt x="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86" name="Rectangle 12"/>
                <p:cNvSpPr>
                  <a:spLocks noChangeArrowheads="1"/>
                </p:cNvSpPr>
                <p:nvPr/>
              </p:nvSpPr>
              <p:spPr bwMode="auto">
                <a:xfrm>
                  <a:off x="2721587" y="1906336"/>
                  <a:ext cx="233512" cy="97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6.2%</a:t>
                  </a:r>
                  <a:endParaRPr kumimoji="0" lang="en-US" sz="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" name="Freeform 13"/>
                <p:cNvSpPr>
                  <a:spLocks/>
                </p:cNvSpPr>
                <p:nvPr/>
              </p:nvSpPr>
              <p:spPr bwMode="auto">
                <a:xfrm>
                  <a:off x="2211498" y="1416425"/>
                  <a:ext cx="836733" cy="83669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2441" y="0"/>
                    </a:cxn>
                    <a:cxn ang="0">
                      <a:pos x="2441" y="2473"/>
                    </a:cxn>
                    <a:cxn ang="0">
                      <a:pos x="0" y="2473"/>
                    </a:cxn>
                    <a:cxn ang="0">
                      <a:pos x="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2441" h="2473">
                      <a:moveTo>
                        <a:pt x="0" y="0"/>
                      </a:moveTo>
                      <a:lnTo>
                        <a:pt x="2441" y="0"/>
                      </a:lnTo>
                      <a:lnTo>
                        <a:pt x="2441" y="2473"/>
                      </a:lnTo>
                      <a:lnTo>
                        <a:pt x="0" y="2473"/>
                      </a:ln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88" name="Line 17"/>
                <p:cNvSpPr>
                  <a:spLocks noChangeShapeType="1"/>
                </p:cNvSpPr>
                <p:nvPr/>
              </p:nvSpPr>
              <p:spPr bwMode="auto">
                <a:xfrm>
                  <a:off x="2270114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89" name="Line 18"/>
                <p:cNvSpPr>
                  <a:spLocks noChangeShapeType="1"/>
                </p:cNvSpPr>
                <p:nvPr/>
              </p:nvSpPr>
              <p:spPr bwMode="auto">
                <a:xfrm>
                  <a:off x="2306107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0" name="Line 19"/>
                <p:cNvSpPr>
                  <a:spLocks noChangeShapeType="1"/>
                </p:cNvSpPr>
                <p:nvPr/>
              </p:nvSpPr>
              <p:spPr bwMode="auto">
                <a:xfrm>
                  <a:off x="2329073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1" name="Line 20"/>
                <p:cNvSpPr>
                  <a:spLocks noChangeShapeType="1"/>
                </p:cNvSpPr>
                <p:nvPr/>
              </p:nvSpPr>
              <p:spPr bwMode="auto">
                <a:xfrm>
                  <a:off x="2348612" y="2256503"/>
                  <a:ext cx="343" cy="1319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2" name="Line 21"/>
                <p:cNvSpPr>
                  <a:spLocks noChangeShapeType="1"/>
                </p:cNvSpPr>
                <p:nvPr/>
              </p:nvSpPr>
              <p:spPr bwMode="auto">
                <a:xfrm>
                  <a:off x="2365065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3" name="Line 22"/>
                <p:cNvSpPr>
                  <a:spLocks noChangeShapeType="1"/>
                </p:cNvSpPr>
                <p:nvPr/>
              </p:nvSpPr>
              <p:spPr bwMode="auto">
                <a:xfrm>
                  <a:off x="2378090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4" name="Line 23"/>
                <p:cNvSpPr>
                  <a:spLocks noChangeShapeType="1"/>
                </p:cNvSpPr>
                <p:nvPr/>
              </p:nvSpPr>
              <p:spPr bwMode="auto">
                <a:xfrm>
                  <a:off x="2391117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5" name="Line 24"/>
                <p:cNvSpPr>
                  <a:spLocks noChangeShapeType="1"/>
                </p:cNvSpPr>
                <p:nvPr/>
              </p:nvSpPr>
              <p:spPr bwMode="auto">
                <a:xfrm>
                  <a:off x="2401058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6" name="Line 25"/>
                <p:cNvSpPr>
                  <a:spLocks noChangeShapeType="1"/>
                </p:cNvSpPr>
                <p:nvPr/>
              </p:nvSpPr>
              <p:spPr bwMode="auto">
                <a:xfrm>
                  <a:off x="2407570" y="2256503"/>
                  <a:ext cx="343" cy="1962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7" name="Line 28"/>
                <p:cNvSpPr>
                  <a:spLocks noChangeShapeType="1"/>
                </p:cNvSpPr>
                <p:nvPr/>
              </p:nvSpPr>
              <p:spPr bwMode="auto">
                <a:xfrm>
                  <a:off x="2469614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8" name="Line 29"/>
                <p:cNvSpPr>
                  <a:spLocks noChangeShapeType="1"/>
                </p:cNvSpPr>
                <p:nvPr/>
              </p:nvSpPr>
              <p:spPr bwMode="auto">
                <a:xfrm>
                  <a:off x="2502178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99" name="Line 30"/>
                <p:cNvSpPr>
                  <a:spLocks noChangeShapeType="1"/>
                </p:cNvSpPr>
                <p:nvPr/>
              </p:nvSpPr>
              <p:spPr bwMode="auto">
                <a:xfrm>
                  <a:off x="2528573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0" name="Line 31"/>
                <p:cNvSpPr>
                  <a:spLocks noChangeShapeType="1"/>
                </p:cNvSpPr>
                <p:nvPr/>
              </p:nvSpPr>
              <p:spPr bwMode="auto">
                <a:xfrm>
                  <a:off x="2548111" y="2256503"/>
                  <a:ext cx="343" cy="1319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1" name="Line 32"/>
                <p:cNvSpPr>
                  <a:spLocks noChangeShapeType="1"/>
                </p:cNvSpPr>
                <p:nvPr/>
              </p:nvSpPr>
              <p:spPr bwMode="auto">
                <a:xfrm>
                  <a:off x="2561137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2" name="Line 33"/>
                <p:cNvSpPr>
                  <a:spLocks noChangeShapeType="1"/>
                </p:cNvSpPr>
                <p:nvPr/>
              </p:nvSpPr>
              <p:spPr bwMode="auto">
                <a:xfrm>
                  <a:off x="2574162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3" name="Line 34"/>
                <p:cNvSpPr>
                  <a:spLocks noChangeShapeType="1"/>
                </p:cNvSpPr>
                <p:nvPr/>
              </p:nvSpPr>
              <p:spPr bwMode="auto">
                <a:xfrm>
                  <a:off x="2587189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4" name="Line 35"/>
                <p:cNvSpPr>
                  <a:spLocks noChangeShapeType="1"/>
                </p:cNvSpPr>
                <p:nvPr/>
              </p:nvSpPr>
              <p:spPr bwMode="auto">
                <a:xfrm>
                  <a:off x="2597129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5" name="Line 36"/>
                <p:cNvSpPr>
                  <a:spLocks noChangeShapeType="1"/>
                </p:cNvSpPr>
                <p:nvPr/>
              </p:nvSpPr>
              <p:spPr bwMode="auto">
                <a:xfrm>
                  <a:off x="2606727" y="2256503"/>
                  <a:ext cx="343" cy="1962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6" name="Line 39"/>
                <p:cNvSpPr>
                  <a:spLocks noChangeShapeType="1"/>
                </p:cNvSpPr>
                <p:nvPr/>
              </p:nvSpPr>
              <p:spPr bwMode="auto">
                <a:xfrm>
                  <a:off x="2665685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7" name="Line 40"/>
                <p:cNvSpPr>
                  <a:spLocks noChangeShapeType="1"/>
                </p:cNvSpPr>
                <p:nvPr/>
              </p:nvSpPr>
              <p:spPr bwMode="auto">
                <a:xfrm>
                  <a:off x="2701678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8" name="Line 41"/>
                <p:cNvSpPr>
                  <a:spLocks noChangeShapeType="1"/>
                </p:cNvSpPr>
                <p:nvPr/>
              </p:nvSpPr>
              <p:spPr bwMode="auto">
                <a:xfrm>
                  <a:off x="2724644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09" name="Line 42"/>
                <p:cNvSpPr>
                  <a:spLocks noChangeShapeType="1"/>
                </p:cNvSpPr>
                <p:nvPr/>
              </p:nvSpPr>
              <p:spPr bwMode="auto">
                <a:xfrm>
                  <a:off x="2744183" y="2256503"/>
                  <a:ext cx="343" cy="1319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0" name="Line 43"/>
                <p:cNvSpPr>
                  <a:spLocks noChangeShapeType="1"/>
                </p:cNvSpPr>
                <p:nvPr/>
              </p:nvSpPr>
              <p:spPr bwMode="auto">
                <a:xfrm>
                  <a:off x="2760636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1" name="Line 44"/>
                <p:cNvSpPr>
                  <a:spLocks noChangeShapeType="1"/>
                </p:cNvSpPr>
                <p:nvPr/>
              </p:nvSpPr>
              <p:spPr bwMode="auto">
                <a:xfrm>
                  <a:off x="2773662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2" name="Line 45"/>
                <p:cNvSpPr>
                  <a:spLocks noChangeShapeType="1"/>
                </p:cNvSpPr>
                <p:nvPr/>
              </p:nvSpPr>
              <p:spPr bwMode="auto">
                <a:xfrm>
                  <a:off x="2783260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3" name="Line 46"/>
                <p:cNvSpPr>
                  <a:spLocks noChangeShapeType="1"/>
                </p:cNvSpPr>
                <p:nvPr/>
              </p:nvSpPr>
              <p:spPr bwMode="auto">
                <a:xfrm>
                  <a:off x="2796286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4" name="Line 47"/>
                <p:cNvSpPr>
                  <a:spLocks noChangeShapeType="1"/>
                </p:cNvSpPr>
                <p:nvPr/>
              </p:nvSpPr>
              <p:spPr bwMode="auto">
                <a:xfrm>
                  <a:off x="2803141" y="2256503"/>
                  <a:ext cx="343" cy="1962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5" name="Line 50"/>
                <p:cNvSpPr>
                  <a:spLocks noChangeShapeType="1"/>
                </p:cNvSpPr>
                <p:nvPr/>
              </p:nvSpPr>
              <p:spPr bwMode="auto">
                <a:xfrm>
                  <a:off x="2861757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6" name="Line 51"/>
                <p:cNvSpPr>
                  <a:spLocks noChangeShapeType="1"/>
                </p:cNvSpPr>
                <p:nvPr/>
              </p:nvSpPr>
              <p:spPr bwMode="auto">
                <a:xfrm>
                  <a:off x="2897749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7" name="Line 52"/>
                <p:cNvSpPr>
                  <a:spLocks noChangeShapeType="1"/>
                </p:cNvSpPr>
                <p:nvPr/>
              </p:nvSpPr>
              <p:spPr bwMode="auto">
                <a:xfrm>
                  <a:off x="2923801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8" name="Line 53"/>
                <p:cNvSpPr>
                  <a:spLocks noChangeShapeType="1"/>
                </p:cNvSpPr>
                <p:nvPr/>
              </p:nvSpPr>
              <p:spPr bwMode="auto">
                <a:xfrm>
                  <a:off x="2943339" y="2256503"/>
                  <a:ext cx="343" cy="1319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19" name="Line 54"/>
                <p:cNvSpPr>
                  <a:spLocks noChangeShapeType="1"/>
                </p:cNvSpPr>
                <p:nvPr/>
              </p:nvSpPr>
              <p:spPr bwMode="auto">
                <a:xfrm>
                  <a:off x="2956708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20" name="Line 55"/>
                <p:cNvSpPr>
                  <a:spLocks noChangeShapeType="1"/>
                </p:cNvSpPr>
                <p:nvPr/>
              </p:nvSpPr>
              <p:spPr bwMode="auto">
                <a:xfrm>
                  <a:off x="2969734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21" name="Line 56"/>
                <p:cNvSpPr>
                  <a:spLocks noChangeShapeType="1"/>
                </p:cNvSpPr>
                <p:nvPr/>
              </p:nvSpPr>
              <p:spPr bwMode="auto">
                <a:xfrm>
                  <a:off x="2982759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22" name="Line 57"/>
                <p:cNvSpPr>
                  <a:spLocks noChangeShapeType="1"/>
                </p:cNvSpPr>
                <p:nvPr/>
              </p:nvSpPr>
              <p:spPr bwMode="auto">
                <a:xfrm>
                  <a:off x="2992700" y="2256503"/>
                  <a:ext cx="343" cy="64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sp>
              <p:nvSpPr>
                <p:cNvPr id="123" name="Line 58"/>
                <p:cNvSpPr>
                  <a:spLocks noChangeShapeType="1"/>
                </p:cNvSpPr>
                <p:nvPr/>
              </p:nvSpPr>
              <p:spPr bwMode="auto">
                <a:xfrm>
                  <a:off x="3002298" y="2256503"/>
                  <a:ext cx="343" cy="1962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/>
                </a:p>
              </p:txBody>
            </p:sp>
            <p:grpSp>
              <p:nvGrpSpPr>
                <p:cNvPr id="124" name="Group 314"/>
                <p:cNvGrpSpPr/>
                <p:nvPr/>
              </p:nvGrpSpPr>
              <p:grpSpPr>
                <a:xfrm>
                  <a:off x="2188532" y="1448905"/>
                  <a:ext cx="23309" cy="827221"/>
                  <a:chOff x="2188532" y="1448905"/>
                  <a:chExt cx="23309" cy="827221"/>
                </a:xfrm>
              </p:grpSpPr>
              <p:sp>
                <p:nvSpPr>
                  <p:cNvPr id="126" name="Line 14"/>
                  <p:cNvSpPr>
                    <a:spLocks noChangeShapeType="1"/>
                  </p:cNvSpPr>
                  <p:nvPr/>
                </p:nvSpPr>
                <p:spPr bwMode="auto">
                  <a:xfrm>
                    <a:off x="2211498" y="2256503"/>
                    <a:ext cx="343" cy="19623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27" name="Line 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88532" y="2253119"/>
                    <a:ext cx="19539" cy="339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28" name="Line 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2187821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29" name="Line 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2119139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0" name="Line 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2053842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1" name="Line 7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88532" y="1985160"/>
                    <a:ext cx="19539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2" name="Line 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1919863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3" name="Line 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1851181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4" name="Line 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1785883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5" name="Line 7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88532" y="1717202"/>
                    <a:ext cx="19539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6" name="Line 7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1648520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7" name="Line 7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1582884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8" name="Line 7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01557" y="1514203"/>
                    <a:ext cx="6513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39" name="Line 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88532" y="1448905"/>
                    <a:ext cx="19539" cy="339"/>
                  </a:xfrm>
                  <a:prstGeom prst="line">
                    <a:avLst/>
                  </a:prstGeom>
                  <a:noFill/>
                  <a:ln w="1587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</p:grp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2680082" y="2045710"/>
                  <a:ext cx="25767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" name="Group 176"/>
              <p:cNvGrpSpPr/>
              <p:nvPr/>
            </p:nvGrpSpPr>
            <p:grpSpPr>
              <a:xfrm>
                <a:off x="4458919" y="2424889"/>
                <a:ext cx="1008173" cy="136676"/>
                <a:chOff x="2644453" y="2177815"/>
                <a:chExt cx="1266521" cy="171700"/>
              </a:xfrm>
            </p:grpSpPr>
            <p:sp>
              <p:nvSpPr>
                <p:cNvPr id="76" name="TextBox 75"/>
                <p:cNvSpPr txBox="1"/>
                <p:nvPr/>
              </p:nvSpPr>
              <p:spPr>
                <a:xfrm>
                  <a:off x="2644453" y="2177815"/>
                  <a:ext cx="354520" cy="171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he-IL" sz="500" b="1" dirty="0" smtClean="0"/>
                    <a:t>10</a:t>
                  </a:r>
                  <a:r>
                    <a:rPr lang="he-IL" sz="500" b="1" baseline="30000" dirty="0" smtClean="0"/>
                    <a:t>1</a:t>
                  </a:r>
                  <a:endParaRPr lang="he-IL" sz="500" b="1" baseline="30000" dirty="0"/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2808970" y="2177815"/>
                  <a:ext cx="354520" cy="171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he-IL" sz="500" b="1" dirty="0" smtClean="0"/>
                    <a:t>10</a:t>
                  </a:r>
                  <a:r>
                    <a:rPr lang="he-IL" sz="500" b="1" baseline="30000" dirty="0" smtClean="0"/>
                    <a:t>2</a:t>
                  </a:r>
                  <a:endParaRPr lang="he-IL" sz="500" b="1" baseline="30000" dirty="0"/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3056115" y="2177815"/>
                  <a:ext cx="354520" cy="171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he-IL" sz="500" b="1" dirty="0" smtClean="0"/>
                    <a:t>10</a:t>
                  </a:r>
                  <a:r>
                    <a:rPr lang="he-IL" sz="500" b="1" baseline="30000" dirty="0" smtClean="0"/>
                    <a:t>3</a:t>
                  </a:r>
                  <a:endParaRPr lang="he-IL" sz="500" b="1" baseline="30000" dirty="0"/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3301875" y="2177815"/>
                  <a:ext cx="354520" cy="171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he-IL" sz="500" b="1" dirty="0" smtClean="0"/>
                    <a:t>10</a:t>
                  </a:r>
                  <a:r>
                    <a:rPr lang="he-IL" sz="500" b="1" baseline="30000" dirty="0" smtClean="0"/>
                    <a:t>4</a:t>
                  </a:r>
                  <a:endParaRPr lang="he-IL" sz="500" b="1" baseline="30000" dirty="0"/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3556454" y="2177815"/>
                  <a:ext cx="354520" cy="171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he-IL" sz="500" b="1" dirty="0" smtClean="0"/>
                    <a:t>10</a:t>
                  </a:r>
                  <a:r>
                    <a:rPr lang="he-IL" sz="500" b="1" baseline="30000" dirty="0" smtClean="0"/>
                    <a:t>5</a:t>
                  </a:r>
                  <a:endParaRPr lang="he-IL" sz="500" b="1" baseline="30000" dirty="0"/>
                </a:p>
              </p:txBody>
            </p:sp>
          </p:grpSp>
          <p:grpSp>
            <p:nvGrpSpPr>
              <p:cNvPr id="11" name="Group 295"/>
              <p:cNvGrpSpPr/>
              <p:nvPr/>
            </p:nvGrpSpPr>
            <p:grpSpPr>
              <a:xfrm>
                <a:off x="5405907" y="1449587"/>
                <a:ext cx="1008173" cy="1111978"/>
                <a:chOff x="5402299" y="1365827"/>
                <a:chExt cx="1008173" cy="1111978"/>
              </a:xfrm>
            </p:grpSpPr>
            <p:grpSp>
              <p:nvGrpSpPr>
                <p:cNvPr id="13" name="Group 177"/>
                <p:cNvGrpSpPr/>
                <p:nvPr/>
              </p:nvGrpSpPr>
              <p:grpSpPr>
                <a:xfrm>
                  <a:off x="5402299" y="2341129"/>
                  <a:ext cx="1008173" cy="136676"/>
                  <a:chOff x="2644453" y="2177815"/>
                  <a:chExt cx="1266521" cy="171700"/>
                </a:xfrm>
              </p:grpSpPr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2644453" y="2177815"/>
                    <a:ext cx="354520" cy="171700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he-IL" sz="500" b="1" dirty="0" smtClean="0"/>
                      <a:t>10</a:t>
                    </a:r>
                    <a:r>
                      <a:rPr lang="he-IL" sz="500" b="1" baseline="30000" dirty="0" smtClean="0"/>
                      <a:t>1</a:t>
                    </a:r>
                    <a:endParaRPr lang="he-IL" sz="500" b="1" baseline="30000" dirty="0"/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2808970" y="2177815"/>
                    <a:ext cx="354520" cy="171700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he-IL" sz="500" b="1" dirty="0" smtClean="0"/>
                      <a:t>10</a:t>
                    </a:r>
                    <a:r>
                      <a:rPr lang="he-IL" sz="500" b="1" baseline="30000" dirty="0" smtClean="0"/>
                      <a:t>2</a:t>
                    </a:r>
                    <a:endParaRPr lang="he-IL" sz="500" b="1" baseline="30000" dirty="0"/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3056115" y="2177815"/>
                    <a:ext cx="354520" cy="171700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he-IL" sz="500" b="1" dirty="0" smtClean="0"/>
                      <a:t>10</a:t>
                    </a:r>
                    <a:r>
                      <a:rPr lang="he-IL" sz="500" b="1" baseline="30000" dirty="0" smtClean="0"/>
                      <a:t>3</a:t>
                    </a:r>
                    <a:endParaRPr lang="he-IL" sz="500" b="1" baseline="30000" dirty="0"/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3301875" y="2177815"/>
                    <a:ext cx="354520" cy="171700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he-IL" sz="500" b="1" dirty="0" smtClean="0"/>
                      <a:t>10</a:t>
                    </a:r>
                    <a:r>
                      <a:rPr lang="he-IL" sz="500" b="1" baseline="30000" dirty="0" smtClean="0"/>
                      <a:t>4</a:t>
                    </a:r>
                    <a:endParaRPr lang="he-IL" sz="500" b="1" baseline="30000" dirty="0"/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3556454" y="2177815"/>
                    <a:ext cx="354520" cy="171700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he-IL" sz="500" b="1" dirty="0" smtClean="0"/>
                      <a:t>10</a:t>
                    </a:r>
                    <a:r>
                      <a:rPr lang="he-IL" sz="500" b="1" baseline="30000" dirty="0" smtClean="0"/>
                      <a:t>5</a:t>
                    </a:r>
                    <a:endParaRPr lang="he-IL" sz="500" b="1" baseline="30000" dirty="0"/>
                  </a:p>
                </p:txBody>
              </p:sp>
            </p:grpSp>
            <p:grpSp>
              <p:nvGrpSpPr>
                <p:cNvPr id="14" name="Group 347"/>
                <p:cNvGrpSpPr/>
                <p:nvPr/>
              </p:nvGrpSpPr>
              <p:grpSpPr>
                <a:xfrm>
                  <a:off x="5435725" y="1514456"/>
                  <a:ext cx="860667" cy="861748"/>
                  <a:chOff x="3299671" y="1514456"/>
                  <a:chExt cx="860667" cy="861748"/>
                </a:xfrm>
              </p:grpSpPr>
              <p:sp>
                <p:nvSpPr>
                  <p:cNvPr id="16" name="Freeform 6"/>
                  <p:cNvSpPr>
                    <a:spLocks/>
                  </p:cNvSpPr>
                  <p:nvPr/>
                </p:nvSpPr>
                <p:spPr bwMode="auto">
                  <a:xfrm>
                    <a:off x="3323606" y="1545696"/>
                    <a:ext cx="836732" cy="807205"/>
                  </a:xfrm>
                  <a:custGeom>
                    <a:avLst/>
                    <a:gdLst/>
                    <a:ahLst/>
                    <a:cxnLst>
                      <a:cxn ang="0">
                        <a:pos x="19" y="2329"/>
                      </a:cxn>
                      <a:cxn ang="0">
                        <a:pos x="67" y="2320"/>
                      </a:cxn>
                      <a:cxn ang="0">
                        <a:pos x="114" y="2300"/>
                      </a:cxn>
                      <a:cxn ang="0">
                        <a:pos x="162" y="2291"/>
                      </a:cxn>
                      <a:cxn ang="0">
                        <a:pos x="210" y="2281"/>
                      </a:cxn>
                      <a:cxn ang="0">
                        <a:pos x="257" y="2194"/>
                      </a:cxn>
                      <a:cxn ang="0">
                        <a:pos x="305" y="2184"/>
                      </a:cxn>
                      <a:cxn ang="0">
                        <a:pos x="353" y="2126"/>
                      </a:cxn>
                      <a:cxn ang="0">
                        <a:pos x="400" y="2011"/>
                      </a:cxn>
                      <a:cxn ang="0">
                        <a:pos x="448" y="1933"/>
                      </a:cxn>
                      <a:cxn ang="0">
                        <a:pos x="496" y="1788"/>
                      </a:cxn>
                      <a:cxn ang="0">
                        <a:pos x="543" y="1605"/>
                      </a:cxn>
                      <a:cxn ang="0">
                        <a:pos x="591" y="1344"/>
                      </a:cxn>
                      <a:cxn ang="0">
                        <a:pos x="639" y="977"/>
                      </a:cxn>
                      <a:cxn ang="0">
                        <a:pos x="686" y="696"/>
                      </a:cxn>
                      <a:cxn ang="0">
                        <a:pos x="734" y="213"/>
                      </a:cxn>
                      <a:cxn ang="0">
                        <a:pos x="782" y="97"/>
                      </a:cxn>
                      <a:cxn ang="0">
                        <a:pos x="829" y="145"/>
                      </a:cxn>
                      <a:cxn ang="0">
                        <a:pos x="877" y="629"/>
                      </a:cxn>
                      <a:cxn ang="0">
                        <a:pos x="925" y="1286"/>
                      </a:cxn>
                      <a:cxn ang="0">
                        <a:pos x="972" y="1827"/>
                      </a:cxn>
                      <a:cxn ang="0">
                        <a:pos x="1020" y="2107"/>
                      </a:cxn>
                      <a:cxn ang="0">
                        <a:pos x="1068" y="2252"/>
                      </a:cxn>
                      <a:cxn ang="0">
                        <a:pos x="1115" y="2300"/>
                      </a:cxn>
                      <a:cxn ang="0">
                        <a:pos x="1163" y="2329"/>
                      </a:cxn>
                      <a:cxn ang="0">
                        <a:pos x="1211" y="2339"/>
                      </a:cxn>
                      <a:cxn ang="0">
                        <a:pos x="1258" y="2349"/>
                      </a:cxn>
                      <a:cxn ang="0">
                        <a:pos x="1306" y="2349"/>
                      </a:cxn>
                      <a:cxn ang="0">
                        <a:pos x="1354" y="2358"/>
                      </a:cxn>
                      <a:cxn ang="0">
                        <a:pos x="1401" y="2358"/>
                      </a:cxn>
                      <a:cxn ang="0">
                        <a:pos x="1449" y="2358"/>
                      </a:cxn>
                      <a:cxn ang="0">
                        <a:pos x="1497" y="2358"/>
                      </a:cxn>
                      <a:cxn ang="0">
                        <a:pos x="1544" y="2358"/>
                      </a:cxn>
                      <a:cxn ang="0">
                        <a:pos x="1592" y="2368"/>
                      </a:cxn>
                      <a:cxn ang="0">
                        <a:pos x="1640" y="2368"/>
                      </a:cxn>
                      <a:cxn ang="0">
                        <a:pos x="1687" y="2378"/>
                      </a:cxn>
                      <a:cxn ang="0">
                        <a:pos x="1735" y="2378"/>
                      </a:cxn>
                      <a:cxn ang="0">
                        <a:pos x="1783" y="2378"/>
                      </a:cxn>
                      <a:cxn ang="0">
                        <a:pos x="1830" y="2378"/>
                      </a:cxn>
                      <a:cxn ang="0">
                        <a:pos x="1878" y="2378"/>
                      </a:cxn>
                      <a:cxn ang="0">
                        <a:pos x="1926" y="2378"/>
                      </a:cxn>
                      <a:cxn ang="0">
                        <a:pos x="1973" y="2378"/>
                      </a:cxn>
                      <a:cxn ang="0">
                        <a:pos x="2021" y="2378"/>
                      </a:cxn>
                      <a:cxn ang="0">
                        <a:pos x="2069" y="2378"/>
                      </a:cxn>
                      <a:cxn ang="0">
                        <a:pos x="2116" y="2378"/>
                      </a:cxn>
                      <a:cxn ang="0">
                        <a:pos x="2164" y="2378"/>
                      </a:cxn>
                      <a:cxn ang="0">
                        <a:pos x="2212" y="2378"/>
                      </a:cxn>
                      <a:cxn ang="0">
                        <a:pos x="2259" y="2378"/>
                      </a:cxn>
                      <a:cxn ang="0">
                        <a:pos x="2307" y="2378"/>
                      </a:cxn>
                      <a:cxn ang="0">
                        <a:pos x="2355" y="2378"/>
                      </a:cxn>
                      <a:cxn ang="0">
                        <a:pos x="2402" y="2378"/>
                      </a:cxn>
                      <a:cxn ang="0">
                        <a:pos x="2441" y="2378"/>
                      </a:cxn>
                    </a:cxnLst>
                    <a:rect l="0" t="0" r="r" b="b"/>
                    <a:pathLst>
                      <a:path w="2441" h="2378">
                        <a:moveTo>
                          <a:pt x="0" y="2378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9" y="1537"/>
                        </a:lnTo>
                        <a:lnTo>
                          <a:pt x="19" y="2329"/>
                        </a:lnTo>
                        <a:lnTo>
                          <a:pt x="28" y="2320"/>
                        </a:lnTo>
                        <a:lnTo>
                          <a:pt x="38" y="2320"/>
                        </a:lnTo>
                        <a:lnTo>
                          <a:pt x="47" y="2320"/>
                        </a:lnTo>
                        <a:lnTo>
                          <a:pt x="57" y="2310"/>
                        </a:lnTo>
                        <a:lnTo>
                          <a:pt x="67" y="2320"/>
                        </a:lnTo>
                        <a:lnTo>
                          <a:pt x="76" y="2320"/>
                        </a:lnTo>
                        <a:lnTo>
                          <a:pt x="86" y="2320"/>
                        </a:lnTo>
                        <a:lnTo>
                          <a:pt x="95" y="2320"/>
                        </a:lnTo>
                        <a:lnTo>
                          <a:pt x="105" y="2310"/>
                        </a:lnTo>
                        <a:lnTo>
                          <a:pt x="114" y="2300"/>
                        </a:lnTo>
                        <a:lnTo>
                          <a:pt x="124" y="2291"/>
                        </a:lnTo>
                        <a:lnTo>
                          <a:pt x="133" y="2291"/>
                        </a:lnTo>
                        <a:lnTo>
                          <a:pt x="143" y="2281"/>
                        </a:lnTo>
                        <a:lnTo>
                          <a:pt x="152" y="2291"/>
                        </a:lnTo>
                        <a:lnTo>
                          <a:pt x="162" y="2291"/>
                        </a:lnTo>
                        <a:lnTo>
                          <a:pt x="171" y="2281"/>
                        </a:lnTo>
                        <a:lnTo>
                          <a:pt x="181" y="2262"/>
                        </a:lnTo>
                        <a:lnTo>
                          <a:pt x="190" y="2262"/>
                        </a:lnTo>
                        <a:lnTo>
                          <a:pt x="200" y="2281"/>
                        </a:lnTo>
                        <a:lnTo>
                          <a:pt x="210" y="2281"/>
                        </a:lnTo>
                        <a:lnTo>
                          <a:pt x="219" y="2271"/>
                        </a:lnTo>
                        <a:lnTo>
                          <a:pt x="229" y="2252"/>
                        </a:lnTo>
                        <a:lnTo>
                          <a:pt x="238" y="2242"/>
                        </a:lnTo>
                        <a:lnTo>
                          <a:pt x="248" y="2233"/>
                        </a:lnTo>
                        <a:lnTo>
                          <a:pt x="257" y="2194"/>
                        </a:lnTo>
                        <a:lnTo>
                          <a:pt x="267" y="2165"/>
                        </a:lnTo>
                        <a:lnTo>
                          <a:pt x="276" y="2184"/>
                        </a:lnTo>
                        <a:lnTo>
                          <a:pt x="286" y="2213"/>
                        </a:lnTo>
                        <a:lnTo>
                          <a:pt x="295" y="2213"/>
                        </a:lnTo>
                        <a:lnTo>
                          <a:pt x="305" y="2184"/>
                        </a:lnTo>
                        <a:lnTo>
                          <a:pt x="314" y="2146"/>
                        </a:lnTo>
                        <a:lnTo>
                          <a:pt x="324" y="2136"/>
                        </a:lnTo>
                        <a:lnTo>
                          <a:pt x="333" y="2117"/>
                        </a:lnTo>
                        <a:lnTo>
                          <a:pt x="343" y="2117"/>
                        </a:lnTo>
                        <a:lnTo>
                          <a:pt x="353" y="2126"/>
                        </a:lnTo>
                        <a:lnTo>
                          <a:pt x="362" y="2117"/>
                        </a:lnTo>
                        <a:lnTo>
                          <a:pt x="372" y="2069"/>
                        </a:lnTo>
                        <a:lnTo>
                          <a:pt x="381" y="2030"/>
                        </a:lnTo>
                        <a:lnTo>
                          <a:pt x="391" y="2011"/>
                        </a:lnTo>
                        <a:lnTo>
                          <a:pt x="400" y="2011"/>
                        </a:lnTo>
                        <a:lnTo>
                          <a:pt x="410" y="2011"/>
                        </a:lnTo>
                        <a:lnTo>
                          <a:pt x="419" y="1991"/>
                        </a:lnTo>
                        <a:lnTo>
                          <a:pt x="429" y="1982"/>
                        </a:lnTo>
                        <a:lnTo>
                          <a:pt x="438" y="1982"/>
                        </a:lnTo>
                        <a:lnTo>
                          <a:pt x="448" y="1933"/>
                        </a:lnTo>
                        <a:lnTo>
                          <a:pt x="457" y="1866"/>
                        </a:lnTo>
                        <a:lnTo>
                          <a:pt x="467" y="1875"/>
                        </a:lnTo>
                        <a:lnTo>
                          <a:pt x="476" y="1866"/>
                        </a:lnTo>
                        <a:lnTo>
                          <a:pt x="486" y="1866"/>
                        </a:lnTo>
                        <a:lnTo>
                          <a:pt x="496" y="1788"/>
                        </a:lnTo>
                        <a:lnTo>
                          <a:pt x="505" y="1711"/>
                        </a:lnTo>
                        <a:lnTo>
                          <a:pt x="515" y="1701"/>
                        </a:lnTo>
                        <a:lnTo>
                          <a:pt x="524" y="1643"/>
                        </a:lnTo>
                        <a:lnTo>
                          <a:pt x="534" y="1537"/>
                        </a:lnTo>
                        <a:lnTo>
                          <a:pt x="543" y="1605"/>
                        </a:lnTo>
                        <a:lnTo>
                          <a:pt x="553" y="1605"/>
                        </a:lnTo>
                        <a:lnTo>
                          <a:pt x="562" y="1450"/>
                        </a:lnTo>
                        <a:lnTo>
                          <a:pt x="572" y="1392"/>
                        </a:lnTo>
                        <a:lnTo>
                          <a:pt x="581" y="1373"/>
                        </a:lnTo>
                        <a:lnTo>
                          <a:pt x="591" y="1344"/>
                        </a:lnTo>
                        <a:lnTo>
                          <a:pt x="600" y="1315"/>
                        </a:lnTo>
                        <a:lnTo>
                          <a:pt x="610" y="1257"/>
                        </a:lnTo>
                        <a:lnTo>
                          <a:pt x="620" y="1073"/>
                        </a:lnTo>
                        <a:lnTo>
                          <a:pt x="629" y="1006"/>
                        </a:lnTo>
                        <a:lnTo>
                          <a:pt x="639" y="977"/>
                        </a:lnTo>
                        <a:lnTo>
                          <a:pt x="648" y="977"/>
                        </a:lnTo>
                        <a:lnTo>
                          <a:pt x="658" y="909"/>
                        </a:lnTo>
                        <a:lnTo>
                          <a:pt x="667" y="774"/>
                        </a:lnTo>
                        <a:lnTo>
                          <a:pt x="677" y="841"/>
                        </a:lnTo>
                        <a:lnTo>
                          <a:pt x="686" y="696"/>
                        </a:lnTo>
                        <a:lnTo>
                          <a:pt x="696" y="600"/>
                        </a:lnTo>
                        <a:lnTo>
                          <a:pt x="705" y="484"/>
                        </a:lnTo>
                        <a:lnTo>
                          <a:pt x="715" y="590"/>
                        </a:lnTo>
                        <a:lnTo>
                          <a:pt x="724" y="406"/>
                        </a:lnTo>
                        <a:lnTo>
                          <a:pt x="734" y="213"/>
                        </a:lnTo>
                        <a:lnTo>
                          <a:pt x="743" y="310"/>
                        </a:lnTo>
                        <a:lnTo>
                          <a:pt x="753" y="203"/>
                        </a:lnTo>
                        <a:lnTo>
                          <a:pt x="763" y="184"/>
                        </a:lnTo>
                        <a:lnTo>
                          <a:pt x="772" y="184"/>
                        </a:lnTo>
                        <a:lnTo>
                          <a:pt x="782" y="97"/>
                        </a:lnTo>
                        <a:lnTo>
                          <a:pt x="791" y="290"/>
                        </a:lnTo>
                        <a:lnTo>
                          <a:pt x="801" y="174"/>
                        </a:lnTo>
                        <a:lnTo>
                          <a:pt x="810" y="97"/>
                        </a:lnTo>
                        <a:lnTo>
                          <a:pt x="820" y="203"/>
                        </a:lnTo>
                        <a:lnTo>
                          <a:pt x="829" y="145"/>
                        </a:lnTo>
                        <a:lnTo>
                          <a:pt x="839" y="252"/>
                        </a:lnTo>
                        <a:lnTo>
                          <a:pt x="848" y="368"/>
                        </a:lnTo>
                        <a:lnTo>
                          <a:pt x="858" y="397"/>
                        </a:lnTo>
                        <a:lnTo>
                          <a:pt x="867" y="561"/>
                        </a:lnTo>
                        <a:lnTo>
                          <a:pt x="877" y="629"/>
                        </a:lnTo>
                        <a:lnTo>
                          <a:pt x="886" y="812"/>
                        </a:lnTo>
                        <a:lnTo>
                          <a:pt x="896" y="899"/>
                        </a:lnTo>
                        <a:lnTo>
                          <a:pt x="906" y="1054"/>
                        </a:lnTo>
                        <a:lnTo>
                          <a:pt x="915" y="1131"/>
                        </a:lnTo>
                        <a:lnTo>
                          <a:pt x="925" y="1286"/>
                        </a:lnTo>
                        <a:lnTo>
                          <a:pt x="934" y="1411"/>
                        </a:lnTo>
                        <a:lnTo>
                          <a:pt x="944" y="1518"/>
                        </a:lnTo>
                        <a:lnTo>
                          <a:pt x="953" y="1624"/>
                        </a:lnTo>
                        <a:lnTo>
                          <a:pt x="963" y="1730"/>
                        </a:lnTo>
                        <a:lnTo>
                          <a:pt x="972" y="1827"/>
                        </a:lnTo>
                        <a:lnTo>
                          <a:pt x="982" y="1895"/>
                        </a:lnTo>
                        <a:lnTo>
                          <a:pt x="991" y="1962"/>
                        </a:lnTo>
                        <a:lnTo>
                          <a:pt x="1001" y="2030"/>
                        </a:lnTo>
                        <a:lnTo>
                          <a:pt x="1010" y="2069"/>
                        </a:lnTo>
                        <a:lnTo>
                          <a:pt x="1020" y="2107"/>
                        </a:lnTo>
                        <a:lnTo>
                          <a:pt x="1029" y="2146"/>
                        </a:lnTo>
                        <a:lnTo>
                          <a:pt x="1039" y="2175"/>
                        </a:lnTo>
                        <a:lnTo>
                          <a:pt x="1049" y="2213"/>
                        </a:lnTo>
                        <a:lnTo>
                          <a:pt x="1058" y="2233"/>
                        </a:lnTo>
                        <a:lnTo>
                          <a:pt x="1068" y="2252"/>
                        </a:lnTo>
                        <a:lnTo>
                          <a:pt x="1077" y="2262"/>
                        </a:lnTo>
                        <a:lnTo>
                          <a:pt x="1087" y="2281"/>
                        </a:lnTo>
                        <a:lnTo>
                          <a:pt x="1096" y="2281"/>
                        </a:lnTo>
                        <a:lnTo>
                          <a:pt x="1106" y="2291"/>
                        </a:lnTo>
                        <a:lnTo>
                          <a:pt x="1115" y="2300"/>
                        </a:lnTo>
                        <a:lnTo>
                          <a:pt x="1125" y="2300"/>
                        </a:lnTo>
                        <a:lnTo>
                          <a:pt x="1134" y="2310"/>
                        </a:lnTo>
                        <a:lnTo>
                          <a:pt x="1144" y="2320"/>
                        </a:lnTo>
                        <a:lnTo>
                          <a:pt x="1153" y="2320"/>
                        </a:lnTo>
                        <a:lnTo>
                          <a:pt x="1163" y="2329"/>
                        </a:lnTo>
                        <a:lnTo>
                          <a:pt x="1173" y="2329"/>
                        </a:lnTo>
                        <a:lnTo>
                          <a:pt x="1182" y="2329"/>
                        </a:lnTo>
                        <a:lnTo>
                          <a:pt x="1192" y="2339"/>
                        </a:lnTo>
                        <a:lnTo>
                          <a:pt x="1201" y="2339"/>
                        </a:lnTo>
                        <a:lnTo>
                          <a:pt x="1211" y="2339"/>
                        </a:lnTo>
                        <a:lnTo>
                          <a:pt x="1220" y="2339"/>
                        </a:lnTo>
                        <a:lnTo>
                          <a:pt x="1230" y="2339"/>
                        </a:lnTo>
                        <a:lnTo>
                          <a:pt x="1239" y="2339"/>
                        </a:lnTo>
                        <a:lnTo>
                          <a:pt x="1249" y="2349"/>
                        </a:lnTo>
                        <a:lnTo>
                          <a:pt x="1258" y="2349"/>
                        </a:lnTo>
                        <a:lnTo>
                          <a:pt x="1268" y="2349"/>
                        </a:lnTo>
                        <a:lnTo>
                          <a:pt x="1277" y="2349"/>
                        </a:lnTo>
                        <a:lnTo>
                          <a:pt x="1287" y="2349"/>
                        </a:lnTo>
                        <a:lnTo>
                          <a:pt x="1296" y="2349"/>
                        </a:lnTo>
                        <a:lnTo>
                          <a:pt x="1306" y="2349"/>
                        </a:lnTo>
                        <a:lnTo>
                          <a:pt x="1316" y="2349"/>
                        </a:lnTo>
                        <a:lnTo>
                          <a:pt x="1325" y="2349"/>
                        </a:lnTo>
                        <a:lnTo>
                          <a:pt x="1335" y="2349"/>
                        </a:lnTo>
                        <a:lnTo>
                          <a:pt x="1344" y="2349"/>
                        </a:lnTo>
                        <a:lnTo>
                          <a:pt x="1354" y="2358"/>
                        </a:lnTo>
                        <a:lnTo>
                          <a:pt x="1363" y="2358"/>
                        </a:lnTo>
                        <a:lnTo>
                          <a:pt x="1373" y="2358"/>
                        </a:lnTo>
                        <a:lnTo>
                          <a:pt x="1382" y="2358"/>
                        </a:lnTo>
                        <a:lnTo>
                          <a:pt x="1392" y="2358"/>
                        </a:lnTo>
                        <a:lnTo>
                          <a:pt x="1401" y="2358"/>
                        </a:lnTo>
                        <a:lnTo>
                          <a:pt x="1411" y="2358"/>
                        </a:lnTo>
                        <a:lnTo>
                          <a:pt x="1420" y="2358"/>
                        </a:lnTo>
                        <a:lnTo>
                          <a:pt x="1430" y="2358"/>
                        </a:lnTo>
                        <a:lnTo>
                          <a:pt x="1439" y="2358"/>
                        </a:lnTo>
                        <a:lnTo>
                          <a:pt x="1449" y="2358"/>
                        </a:lnTo>
                        <a:lnTo>
                          <a:pt x="1459" y="2358"/>
                        </a:lnTo>
                        <a:lnTo>
                          <a:pt x="1468" y="2358"/>
                        </a:lnTo>
                        <a:lnTo>
                          <a:pt x="1478" y="2358"/>
                        </a:lnTo>
                        <a:lnTo>
                          <a:pt x="1487" y="2358"/>
                        </a:lnTo>
                        <a:lnTo>
                          <a:pt x="1497" y="2358"/>
                        </a:lnTo>
                        <a:lnTo>
                          <a:pt x="1506" y="2358"/>
                        </a:lnTo>
                        <a:lnTo>
                          <a:pt x="1516" y="2358"/>
                        </a:lnTo>
                        <a:lnTo>
                          <a:pt x="1525" y="2358"/>
                        </a:lnTo>
                        <a:lnTo>
                          <a:pt x="1535" y="2358"/>
                        </a:lnTo>
                        <a:lnTo>
                          <a:pt x="1544" y="2358"/>
                        </a:lnTo>
                        <a:lnTo>
                          <a:pt x="1554" y="2358"/>
                        </a:lnTo>
                        <a:lnTo>
                          <a:pt x="1563" y="2368"/>
                        </a:lnTo>
                        <a:lnTo>
                          <a:pt x="1573" y="2368"/>
                        </a:lnTo>
                        <a:lnTo>
                          <a:pt x="1582" y="2368"/>
                        </a:lnTo>
                        <a:lnTo>
                          <a:pt x="1592" y="2368"/>
                        </a:lnTo>
                        <a:lnTo>
                          <a:pt x="1602" y="2368"/>
                        </a:lnTo>
                        <a:lnTo>
                          <a:pt x="1611" y="2368"/>
                        </a:lnTo>
                        <a:lnTo>
                          <a:pt x="1621" y="2368"/>
                        </a:lnTo>
                        <a:lnTo>
                          <a:pt x="1630" y="2368"/>
                        </a:lnTo>
                        <a:lnTo>
                          <a:pt x="1640" y="2368"/>
                        </a:lnTo>
                        <a:lnTo>
                          <a:pt x="1649" y="2368"/>
                        </a:lnTo>
                        <a:lnTo>
                          <a:pt x="1659" y="2368"/>
                        </a:lnTo>
                        <a:lnTo>
                          <a:pt x="1668" y="2368"/>
                        </a:lnTo>
                        <a:lnTo>
                          <a:pt x="1678" y="2368"/>
                        </a:lnTo>
                        <a:lnTo>
                          <a:pt x="1687" y="2378"/>
                        </a:lnTo>
                        <a:lnTo>
                          <a:pt x="1697" y="2378"/>
                        </a:lnTo>
                        <a:lnTo>
                          <a:pt x="1706" y="2378"/>
                        </a:lnTo>
                        <a:lnTo>
                          <a:pt x="1716" y="2378"/>
                        </a:lnTo>
                        <a:lnTo>
                          <a:pt x="1726" y="2378"/>
                        </a:lnTo>
                        <a:lnTo>
                          <a:pt x="1735" y="2378"/>
                        </a:lnTo>
                        <a:lnTo>
                          <a:pt x="1745" y="2378"/>
                        </a:lnTo>
                        <a:lnTo>
                          <a:pt x="1754" y="2378"/>
                        </a:lnTo>
                        <a:lnTo>
                          <a:pt x="1764" y="2378"/>
                        </a:lnTo>
                        <a:lnTo>
                          <a:pt x="1773" y="2378"/>
                        </a:lnTo>
                        <a:lnTo>
                          <a:pt x="1783" y="2378"/>
                        </a:lnTo>
                        <a:lnTo>
                          <a:pt x="1792" y="2378"/>
                        </a:lnTo>
                        <a:lnTo>
                          <a:pt x="1802" y="2378"/>
                        </a:lnTo>
                        <a:lnTo>
                          <a:pt x="1811" y="2378"/>
                        </a:lnTo>
                        <a:lnTo>
                          <a:pt x="1821" y="2378"/>
                        </a:lnTo>
                        <a:lnTo>
                          <a:pt x="1830" y="2378"/>
                        </a:lnTo>
                        <a:lnTo>
                          <a:pt x="1840" y="2378"/>
                        </a:lnTo>
                        <a:lnTo>
                          <a:pt x="1849" y="2378"/>
                        </a:lnTo>
                        <a:lnTo>
                          <a:pt x="1859" y="2378"/>
                        </a:lnTo>
                        <a:lnTo>
                          <a:pt x="1869" y="2378"/>
                        </a:lnTo>
                        <a:lnTo>
                          <a:pt x="1878" y="2378"/>
                        </a:lnTo>
                        <a:lnTo>
                          <a:pt x="1888" y="2378"/>
                        </a:lnTo>
                        <a:lnTo>
                          <a:pt x="1897" y="2378"/>
                        </a:lnTo>
                        <a:lnTo>
                          <a:pt x="1907" y="2378"/>
                        </a:lnTo>
                        <a:lnTo>
                          <a:pt x="1916" y="2378"/>
                        </a:lnTo>
                        <a:lnTo>
                          <a:pt x="1926" y="2378"/>
                        </a:lnTo>
                        <a:lnTo>
                          <a:pt x="1935" y="2378"/>
                        </a:lnTo>
                        <a:lnTo>
                          <a:pt x="1945" y="2378"/>
                        </a:lnTo>
                        <a:lnTo>
                          <a:pt x="1954" y="2378"/>
                        </a:lnTo>
                        <a:lnTo>
                          <a:pt x="1964" y="2378"/>
                        </a:lnTo>
                        <a:lnTo>
                          <a:pt x="1973" y="2378"/>
                        </a:lnTo>
                        <a:lnTo>
                          <a:pt x="1983" y="2378"/>
                        </a:lnTo>
                        <a:lnTo>
                          <a:pt x="1992" y="2378"/>
                        </a:lnTo>
                        <a:lnTo>
                          <a:pt x="2002" y="2378"/>
                        </a:lnTo>
                        <a:lnTo>
                          <a:pt x="2012" y="2378"/>
                        </a:lnTo>
                        <a:lnTo>
                          <a:pt x="2021" y="2378"/>
                        </a:lnTo>
                        <a:lnTo>
                          <a:pt x="2031" y="2378"/>
                        </a:lnTo>
                        <a:lnTo>
                          <a:pt x="2040" y="2378"/>
                        </a:lnTo>
                        <a:lnTo>
                          <a:pt x="2050" y="2378"/>
                        </a:lnTo>
                        <a:lnTo>
                          <a:pt x="2059" y="2378"/>
                        </a:lnTo>
                        <a:lnTo>
                          <a:pt x="2069" y="2378"/>
                        </a:lnTo>
                        <a:lnTo>
                          <a:pt x="2078" y="2378"/>
                        </a:lnTo>
                        <a:lnTo>
                          <a:pt x="2088" y="2378"/>
                        </a:lnTo>
                        <a:lnTo>
                          <a:pt x="2097" y="2378"/>
                        </a:lnTo>
                        <a:lnTo>
                          <a:pt x="2107" y="2378"/>
                        </a:lnTo>
                        <a:lnTo>
                          <a:pt x="2116" y="2378"/>
                        </a:lnTo>
                        <a:lnTo>
                          <a:pt x="2126" y="2378"/>
                        </a:lnTo>
                        <a:lnTo>
                          <a:pt x="2135" y="2378"/>
                        </a:lnTo>
                        <a:lnTo>
                          <a:pt x="2145" y="2378"/>
                        </a:lnTo>
                        <a:lnTo>
                          <a:pt x="2155" y="2378"/>
                        </a:lnTo>
                        <a:lnTo>
                          <a:pt x="2164" y="2378"/>
                        </a:lnTo>
                        <a:lnTo>
                          <a:pt x="2174" y="2378"/>
                        </a:lnTo>
                        <a:lnTo>
                          <a:pt x="2183" y="2378"/>
                        </a:lnTo>
                        <a:lnTo>
                          <a:pt x="2193" y="2378"/>
                        </a:lnTo>
                        <a:lnTo>
                          <a:pt x="2202" y="2378"/>
                        </a:lnTo>
                        <a:lnTo>
                          <a:pt x="2212" y="2378"/>
                        </a:lnTo>
                        <a:lnTo>
                          <a:pt x="2221" y="2378"/>
                        </a:lnTo>
                        <a:lnTo>
                          <a:pt x="2231" y="2378"/>
                        </a:lnTo>
                        <a:lnTo>
                          <a:pt x="2240" y="2378"/>
                        </a:lnTo>
                        <a:lnTo>
                          <a:pt x="2250" y="2378"/>
                        </a:lnTo>
                        <a:lnTo>
                          <a:pt x="2259" y="2378"/>
                        </a:lnTo>
                        <a:lnTo>
                          <a:pt x="2269" y="2378"/>
                        </a:lnTo>
                        <a:lnTo>
                          <a:pt x="2279" y="2378"/>
                        </a:lnTo>
                        <a:lnTo>
                          <a:pt x="2288" y="2378"/>
                        </a:lnTo>
                        <a:lnTo>
                          <a:pt x="2298" y="2378"/>
                        </a:lnTo>
                        <a:lnTo>
                          <a:pt x="2307" y="2378"/>
                        </a:lnTo>
                        <a:lnTo>
                          <a:pt x="2317" y="2378"/>
                        </a:lnTo>
                        <a:lnTo>
                          <a:pt x="2326" y="2378"/>
                        </a:lnTo>
                        <a:lnTo>
                          <a:pt x="2336" y="2378"/>
                        </a:lnTo>
                        <a:lnTo>
                          <a:pt x="2345" y="2378"/>
                        </a:lnTo>
                        <a:lnTo>
                          <a:pt x="2355" y="2378"/>
                        </a:lnTo>
                        <a:lnTo>
                          <a:pt x="2364" y="2378"/>
                        </a:lnTo>
                        <a:lnTo>
                          <a:pt x="2374" y="2378"/>
                        </a:lnTo>
                        <a:lnTo>
                          <a:pt x="2383" y="2378"/>
                        </a:lnTo>
                        <a:lnTo>
                          <a:pt x="2393" y="2378"/>
                        </a:lnTo>
                        <a:lnTo>
                          <a:pt x="2402" y="2378"/>
                        </a:lnTo>
                        <a:lnTo>
                          <a:pt x="2412" y="2378"/>
                        </a:lnTo>
                        <a:lnTo>
                          <a:pt x="2422" y="2378"/>
                        </a:lnTo>
                        <a:lnTo>
                          <a:pt x="2431" y="2368"/>
                        </a:lnTo>
                        <a:lnTo>
                          <a:pt x="2441" y="2368"/>
                        </a:lnTo>
                        <a:lnTo>
                          <a:pt x="2441" y="2378"/>
                        </a:lnTo>
                      </a:path>
                    </a:pathLst>
                  </a:cu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17" name="Rectangle 12"/>
                  <p:cNvSpPr>
                    <a:spLocks noChangeArrowheads="1"/>
                  </p:cNvSpPr>
                  <p:nvPr/>
                </p:nvSpPr>
                <p:spPr bwMode="auto">
                  <a:xfrm>
                    <a:off x="3813254" y="2028116"/>
                    <a:ext cx="233512" cy="97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r" defTabSz="914400" rtl="1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he-IL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1.06%</a:t>
                    </a:r>
                    <a:endParaRPr kumimoji="0" lang="he-IL" sz="8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" name="Freeform 13"/>
                  <p:cNvSpPr>
                    <a:spLocks/>
                  </p:cNvSpPr>
                  <p:nvPr/>
                </p:nvSpPr>
                <p:spPr bwMode="auto">
                  <a:xfrm>
                    <a:off x="3323606" y="1514456"/>
                    <a:ext cx="836732" cy="839452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2441" y="0"/>
                      </a:cxn>
                      <a:cxn ang="0">
                        <a:pos x="2441" y="2473"/>
                      </a:cxn>
                      <a:cxn ang="0">
                        <a:pos x="0" y="2473"/>
                      </a:cxn>
                      <a:cxn ang="0">
                        <a:pos x="0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2441" h="2473">
                        <a:moveTo>
                          <a:pt x="0" y="0"/>
                        </a:moveTo>
                        <a:lnTo>
                          <a:pt x="2441" y="0"/>
                        </a:lnTo>
                        <a:lnTo>
                          <a:pt x="2441" y="2473"/>
                        </a:lnTo>
                        <a:lnTo>
                          <a:pt x="0" y="2473"/>
                        </a:ln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19" name="Line 17"/>
                  <p:cNvSpPr>
                    <a:spLocks noChangeShapeType="1"/>
                  </p:cNvSpPr>
                  <p:nvPr/>
                </p:nvSpPr>
                <p:spPr bwMode="auto">
                  <a:xfrm>
                    <a:off x="3382221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0" name="Line 18"/>
                  <p:cNvSpPr>
                    <a:spLocks noChangeShapeType="1"/>
                  </p:cNvSpPr>
                  <p:nvPr/>
                </p:nvSpPr>
                <p:spPr bwMode="auto">
                  <a:xfrm>
                    <a:off x="3418214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1" name="Line 19"/>
                  <p:cNvSpPr>
                    <a:spLocks noChangeShapeType="1"/>
                  </p:cNvSpPr>
                  <p:nvPr/>
                </p:nvSpPr>
                <p:spPr bwMode="auto">
                  <a:xfrm>
                    <a:off x="3441180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2" name="Line 20"/>
                  <p:cNvSpPr>
                    <a:spLocks noChangeShapeType="1"/>
                  </p:cNvSpPr>
                  <p:nvPr/>
                </p:nvSpPr>
                <p:spPr bwMode="auto">
                  <a:xfrm>
                    <a:off x="3460719" y="2356516"/>
                    <a:ext cx="343" cy="1323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3" name="Line 21"/>
                  <p:cNvSpPr>
                    <a:spLocks noChangeShapeType="1"/>
                  </p:cNvSpPr>
                  <p:nvPr/>
                </p:nvSpPr>
                <p:spPr bwMode="auto">
                  <a:xfrm>
                    <a:off x="3477172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4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3490198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5" name="Line 23"/>
                  <p:cNvSpPr>
                    <a:spLocks noChangeShapeType="1"/>
                  </p:cNvSpPr>
                  <p:nvPr/>
                </p:nvSpPr>
                <p:spPr bwMode="auto">
                  <a:xfrm>
                    <a:off x="3503224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6" name="Line 24"/>
                  <p:cNvSpPr>
                    <a:spLocks noChangeShapeType="1"/>
                  </p:cNvSpPr>
                  <p:nvPr/>
                </p:nvSpPr>
                <p:spPr bwMode="auto">
                  <a:xfrm>
                    <a:off x="3513164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7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3519677" y="2356516"/>
                    <a:ext cx="343" cy="1968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8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3581721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29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3614285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0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3640680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1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3660218" y="2356516"/>
                    <a:ext cx="343" cy="1323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2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3673244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3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3686269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4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3699295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5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3709236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6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3718834" y="2356516"/>
                    <a:ext cx="343" cy="1968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7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3777793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8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3813785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39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3836751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0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3856290" y="2356516"/>
                    <a:ext cx="343" cy="1323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1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3872743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2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3885769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3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3895367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4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3908393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5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3915248" y="2356516"/>
                    <a:ext cx="343" cy="1968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6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3973864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7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4009856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8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4035908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49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4055446" y="2356516"/>
                    <a:ext cx="343" cy="1323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50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4068815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51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4081841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52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4094866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53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4104807" y="2356516"/>
                    <a:ext cx="343" cy="645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sp>
                <p:nvSpPr>
                  <p:cNvPr id="54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4114405" y="2356516"/>
                    <a:ext cx="343" cy="1968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he-IL" sz="1000"/>
                  </a:p>
                </p:txBody>
              </p:sp>
              <p:cxnSp>
                <p:nvCxnSpPr>
                  <p:cNvPr id="55" name="Straight Connector 54"/>
                  <p:cNvCxnSpPr/>
                  <p:nvPr/>
                </p:nvCxnSpPr>
                <p:spPr>
                  <a:xfrm>
                    <a:off x="3782168" y="2162979"/>
                    <a:ext cx="26063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56" name="Group 329"/>
                  <p:cNvGrpSpPr/>
                  <p:nvPr/>
                </p:nvGrpSpPr>
                <p:grpSpPr>
                  <a:xfrm>
                    <a:off x="3299671" y="1547049"/>
                    <a:ext cx="23309" cy="827221"/>
                    <a:chOff x="3275856" y="1412776"/>
                    <a:chExt cx="23309" cy="827221"/>
                  </a:xfrm>
                </p:grpSpPr>
                <p:sp>
                  <p:nvSpPr>
                    <p:cNvPr id="57" name="Line 1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98822" y="2220374"/>
                      <a:ext cx="343" cy="19623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58" name="Line 6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75856" y="2216990"/>
                      <a:ext cx="19539" cy="339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59" name="Line 6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2151692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0" name="Line 6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2083010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1" name="Line 6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2017713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2" name="Line 70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75856" y="1949031"/>
                      <a:ext cx="19539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3" name="Line 71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1883734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4" name="Line 72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1815052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5" name="Line 73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1749754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6" name="Line 74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75856" y="1681073"/>
                      <a:ext cx="19539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7" name="Line 7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1612391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8" name="Line 7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1546755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69" name="Line 7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88881" y="1478074"/>
                      <a:ext cx="6513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  <p:sp>
                  <p:nvSpPr>
                    <p:cNvPr id="70" name="Line 7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3275856" y="1412776"/>
                      <a:ext cx="19539" cy="339"/>
                    </a:xfrm>
                    <a:prstGeom prst="line">
                      <a:avLst/>
                    </a:prstGeom>
                    <a:noFill/>
                    <a:ln w="1587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/>
                    </a:p>
                  </p:txBody>
                </p:sp>
              </p:grpSp>
            </p:grpSp>
            <p:sp>
              <p:nvSpPr>
                <p:cNvPr id="15" name="Rectangle 34"/>
                <p:cNvSpPr>
                  <a:spLocks noChangeArrowheads="1"/>
                </p:cNvSpPr>
                <p:nvPr/>
              </p:nvSpPr>
              <p:spPr bwMode="auto">
                <a:xfrm>
                  <a:off x="5629739" y="1365827"/>
                  <a:ext cx="336980" cy="1143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FTY720</a:t>
                  </a:r>
                  <a:endPara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</p:grpSp>
          <p:sp>
            <p:nvSpPr>
              <p:cNvPr id="12" name="Rectangle 33"/>
              <p:cNvSpPr>
                <a:spLocks noChangeArrowheads="1"/>
              </p:cNvSpPr>
              <p:nvPr/>
            </p:nvSpPr>
            <p:spPr bwMode="auto">
              <a:xfrm>
                <a:off x="4828726" y="1449588"/>
                <a:ext cx="195281" cy="1143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PBS</a:t>
                </a:r>
                <a:endPara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</p:grpSp>
        <p:sp>
          <p:nvSpPr>
            <p:cNvPr id="140" name="Text Box 140"/>
            <p:cNvSpPr txBox="1">
              <a:spLocks noChangeArrowheads="1"/>
            </p:cNvSpPr>
            <p:nvPr/>
          </p:nvSpPr>
          <p:spPr bwMode="auto">
            <a:xfrm>
              <a:off x="2555776" y="2924944"/>
              <a:ext cx="3888433" cy="17081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just" rtl="0">
                <a:lnSpc>
                  <a:spcPct val="150000"/>
                </a:lnSpc>
              </a:pPr>
              <a:r>
                <a:rPr lang="en-US" sz="1000" b="1" dirty="0">
                  <a:latin typeface="+mj-lt"/>
                </a:rPr>
                <a:t>Figure </a:t>
              </a:r>
              <a:r>
                <a:rPr lang="en-US" sz="1000" b="1" dirty="0" smtClean="0">
                  <a:latin typeface="+mj-lt"/>
                </a:rPr>
                <a:t>S4</a:t>
              </a:r>
              <a:r>
                <a:rPr lang="en-US" sz="1000" dirty="0" smtClean="0">
                  <a:latin typeface="+mj-lt"/>
                </a:rPr>
                <a:t>: </a:t>
              </a:r>
              <a:r>
                <a:rPr lang="en-US" sz="1000" b="1" dirty="0" smtClean="0">
                  <a:latin typeface="+mj-lt"/>
                </a:rPr>
                <a:t>Blocking circulating lymphocytes by FTY720. </a:t>
              </a:r>
              <a:r>
                <a:rPr lang="en-US" sz="1000" dirty="0" smtClean="0">
                  <a:latin typeface="+mj-lt"/>
                </a:rPr>
                <a:t>Mice were administered with FTY720 (0.4 mg/ml per mouse) or PBS on a daily basis, starting on day -2 until day 5 of boosting immunization to block circulating lymphocytes. FACS plots are presented demonstrating the impact of FTY720 treatment on the frequency of CD3</a:t>
              </a:r>
              <a:r>
                <a:rPr lang="en-US" sz="1000" baseline="30000" dirty="0" smtClean="0">
                  <a:latin typeface="+mj-lt"/>
                </a:rPr>
                <a:t>+</a:t>
              </a:r>
              <a:r>
                <a:rPr lang="en-US" sz="1000" dirty="0" smtClean="0">
                  <a:latin typeface="+mj-lt"/>
                </a:rPr>
                <a:t> cells in the blood 5 days after the immunization.</a:t>
              </a:r>
              <a:endParaRPr lang="en-US" sz="1000" dirty="0">
                <a:latin typeface="+mj-lt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87</TotalTime>
  <Words>87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vi-Hai Hovav</dc:creator>
  <cp:lastModifiedBy>Avi-Hai Hovav</cp:lastModifiedBy>
  <cp:revision>47</cp:revision>
  <dcterms:created xsi:type="dcterms:W3CDTF">2012-03-08T20:20:35Z</dcterms:created>
  <dcterms:modified xsi:type="dcterms:W3CDTF">2013-04-14T08:31:06Z</dcterms:modified>
</cp:coreProperties>
</file>